
<file path=[Content_Types].xml><?xml version="1.0" encoding="utf-8"?>
<Types xmlns="http://schemas.openxmlformats.org/package/2006/content-types">
  <Default Extension="bin" ContentType="application/vnd.openxmlformats-officedocument.oleObject"/>
  <Default Extension="docx" ContentType="application/vnd.openxmlformats-officedocument.wordprocessingml.documen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1"/>
  </p:notesMasterIdLst>
  <p:sldIdLst>
    <p:sldId id="283" r:id="rId2"/>
    <p:sldId id="284" r:id="rId3"/>
    <p:sldId id="280" r:id="rId4"/>
    <p:sldId id="282" r:id="rId5"/>
    <p:sldId id="266" r:id="rId6"/>
    <p:sldId id="272" r:id="rId7"/>
    <p:sldId id="285" r:id="rId8"/>
    <p:sldId id="286" r:id="rId9"/>
    <p:sldId id="287" r:id="rId10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7D60009-704D-9868-429C-15B572F8C763}" name="Marie-Gabrielle Zurich Fontanellaz" initials="MGZF" userId="S::marie-gabrielle.zurichfontanellaz@unil.ch::010cbe61-fa47-4283-bdec-436c3c4bd110" providerId="AD"/>
  <p188:author id="{B101A918-A8E3-A865-7356-EB6866F457C9}" name="Carolina Martins Resende Alves Nunes" initials="CMRAN" userId="Carolina Martins Resende Alves Nunes" providerId="None"/>
  <p188:author id="{8256EF3F-04FC-C6D7-DCF9-8DA3A2423D0D}" name="Susana Proença" initials="SP" userId="aaaf12d93998139c" providerId="Windows Live"/>
  <p188:author id="{14F54175-9F61-A28F-D818-AE97324F9237}" name="Duarte Lopes Mascarenhas Proenca, Susana" initials="DLMPS" userId="Duarte Lopes Mascarenhas Proenca, Susana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116"/>
    <p:restoredTop sz="94674"/>
  </p:normalViewPr>
  <p:slideViewPr>
    <p:cSldViewPr snapToGrid="0" snapToObjects="1">
      <p:cViewPr varScale="1">
        <p:scale>
          <a:sx n="86" d="100"/>
          <a:sy n="86" d="100"/>
        </p:scale>
        <p:origin x="336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microsoft.com/office/2018/10/relationships/authors" Target="author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aaaf12d93998139c/in3%20-Susana/Carolina%20manuscript/Carolina's%20paper/Ami-TK%20and%20CurveDose%20Resp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aaaf12d93998139c/in3%20-Susana/Carolina%20manuscript/Carolina's%20paper/Ami-TK%20and%20CurveDose%20Resp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uart013\AppData\Local\Microsoft\Windows\INetCache\Content.Outlook\3TMAU2KU\Ami-TK%20and%20CurveDose%20Resp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Residuals for Medium 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Used in optimization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Ami-TK and CurveDose Resp.xlsx]Compar simulations exp '!$D$4:$G$4,'[Ami-TK and CurveDose Resp.xlsx]Compar simulations exp '!$I$4:$J$4,'[Ami-TK and CurveDose Resp.xlsx]Compar simulations exp '!$D$16:$G$16,'[Ami-TK and CurveDose Resp.xlsx]Compar simulations exp '!$I$16:$L$16,'[Ami-TK and CurveDose Resp.xlsx]Compar simulations exp '!$N$16:$O$16</c:f>
              <c:numCache>
                <c:formatCode>General</c:formatCode>
                <c:ptCount val="16"/>
                <c:pt idx="0">
                  <c:v>0.16666666666666666</c:v>
                </c:pt>
                <c:pt idx="1">
                  <c:v>0.23466666666666666</c:v>
                </c:pt>
                <c:pt idx="2">
                  <c:v>0.40266666666666662</c:v>
                </c:pt>
                <c:pt idx="3">
                  <c:v>0</c:v>
                </c:pt>
                <c:pt idx="4">
                  <c:v>0.84133333333333327</c:v>
                </c:pt>
                <c:pt idx="5">
                  <c:v>0.60666666666666669</c:v>
                </c:pt>
                <c:pt idx="6">
                  <c:v>0.65866666666666673</c:v>
                </c:pt>
                <c:pt idx="7">
                  <c:v>0.38533333333333331</c:v>
                </c:pt>
                <c:pt idx="8">
                  <c:v>0.76666666666666672</c:v>
                </c:pt>
                <c:pt idx="9">
                  <c:v>0</c:v>
                </c:pt>
                <c:pt idx="10">
                  <c:v>1.804</c:v>
                </c:pt>
                <c:pt idx="11">
                  <c:v>1.268</c:v>
                </c:pt>
                <c:pt idx="12">
                  <c:v>1.8440000000000001</c:v>
                </c:pt>
                <c:pt idx="13">
                  <c:v>0</c:v>
                </c:pt>
                <c:pt idx="14">
                  <c:v>3.4506666666666668</c:v>
                </c:pt>
                <c:pt idx="15">
                  <c:v>2.0413333333333328</c:v>
                </c:pt>
              </c:numCache>
            </c:numRef>
          </c:xVal>
          <c:yVal>
            <c:numRef>
              <c:f>'[Ami-TK and CurveDose Resp.xlsx]Compar simulations exp '!$D$8:$G$8,'[Ami-TK and CurveDose Resp.xlsx]Compar simulations exp '!$I$8:$J$8,'[Ami-TK and CurveDose Resp.xlsx]Compar simulations exp '!$D$19:$G$19,'[Ami-TK and CurveDose Resp.xlsx]Compar simulations exp '!$I$19:$L$19,'[Ami-TK and CurveDose Resp.xlsx]Compar simulations exp '!$N$19:$O$19</c:f>
              <c:numCache>
                <c:formatCode>General</c:formatCode>
                <c:ptCount val="16"/>
                <c:pt idx="0">
                  <c:v>0.39301403430078402</c:v>
                </c:pt>
                <c:pt idx="1">
                  <c:v>0.38106303505588401</c:v>
                </c:pt>
                <c:pt idx="2">
                  <c:v>0.81077052269738303</c:v>
                </c:pt>
                <c:pt idx="3">
                  <c:v>0.41661690549914598</c:v>
                </c:pt>
                <c:pt idx="4">
                  <c:v>0.76528854172693594</c:v>
                </c:pt>
                <c:pt idx="5">
                  <c:v>0.74201720282655603</c:v>
                </c:pt>
                <c:pt idx="6">
                  <c:v>0.58970082386477096</c:v>
                </c:pt>
                <c:pt idx="7">
                  <c:v>0.55125962343276003</c:v>
                </c:pt>
                <c:pt idx="8">
                  <c:v>0.94828149811400397</c:v>
                </c:pt>
                <c:pt idx="9">
                  <c:v>0.277170612953069</c:v>
                </c:pt>
                <c:pt idx="10">
                  <c:v>1.148336663806</c:v>
                </c:pt>
                <c:pt idx="11">
                  <c:v>1.0734290292703901</c:v>
                </c:pt>
                <c:pt idx="12">
                  <c:v>1.84652175616141</c:v>
                </c:pt>
                <c:pt idx="13">
                  <c:v>0.53971480810028805</c:v>
                </c:pt>
                <c:pt idx="14">
                  <c:v>2.0010310970935699</c:v>
                </c:pt>
                <c:pt idx="15">
                  <c:v>1.870413370571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31B-4618-8DE6-1474DBC4102B}"/>
            </c:ext>
          </c:extLst>
        </c:ser>
        <c:ser>
          <c:idx val="1"/>
          <c:order val="1"/>
          <c:tx>
            <c:v>Not used for optimization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Ami-TK and CurveDose Resp.xlsx]Compar simulations exp '!$K$4:$L$4,'[Ami-TK and CurveDose Resp.xlsx]Compar simulations exp '!$N$4:$O$4</c:f>
              <c:numCache>
                <c:formatCode>General</c:formatCode>
                <c:ptCount val="4"/>
                <c:pt idx="0">
                  <c:v>1.052</c:v>
                </c:pt>
                <c:pt idx="1">
                  <c:v>0</c:v>
                </c:pt>
                <c:pt idx="2">
                  <c:v>1.6160000000000001</c:v>
                </c:pt>
                <c:pt idx="3">
                  <c:v>1.272</c:v>
                </c:pt>
              </c:numCache>
            </c:numRef>
          </c:xVal>
          <c:yVal>
            <c:numRef>
              <c:f>'[Ami-TK and CurveDose Resp.xlsx]Compar simulations exp '!$K$8:$L$8,'[Ami-TK and CurveDose Resp.xlsx]Compar simulations exp '!$N$8:$O$8</c:f>
              <c:numCache>
                <c:formatCode>General</c:formatCode>
                <c:ptCount val="4"/>
                <c:pt idx="0">
                  <c:v>1.52106494531169</c:v>
                </c:pt>
                <c:pt idx="1">
                  <c:v>0.78160386052306596</c:v>
                </c:pt>
                <c:pt idx="2">
                  <c:v>1.3335515781324501</c:v>
                </c:pt>
                <c:pt idx="3">
                  <c:v>1.29297242089476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31B-4618-8DE6-1474DBC4102B}"/>
            </c:ext>
          </c:extLst>
        </c:ser>
        <c:ser>
          <c:idx val="2"/>
          <c:order val="2"/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'[Ami-TK and CurveDose Resp.xlsx]Compar simulations exp '!$R$5:$R$6</c:f>
              <c:numCache>
                <c:formatCode>General</c:formatCode>
                <c:ptCount val="2"/>
                <c:pt idx="0">
                  <c:v>0</c:v>
                </c:pt>
                <c:pt idx="1">
                  <c:v>4</c:v>
                </c:pt>
              </c:numCache>
            </c:numRef>
          </c:xVal>
          <c:yVal>
            <c:numRef>
              <c:f>'[Ami-TK and CurveDose Resp.xlsx]Compar simulations exp '!$S$5:$S$6</c:f>
              <c:numCache>
                <c:formatCode>General</c:formatCode>
                <c:ptCount val="2"/>
                <c:pt idx="0">
                  <c:v>0</c:v>
                </c:pt>
                <c:pt idx="1">
                  <c:v>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031B-4618-8DE6-1474DBC410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56576944"/>
        <c:axId val="756576288"/>
      </c:scatterChart>
      <c:valAx>
        <c:axId val="756576944"/>
        <c:scaling>
          <c:orientation val="minMax"/>
          <c:max val="4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Experimentall amount of</a:t>
                </a:r>
                <a:r>
                  <a:rPr lang="en-US" baseline="0"/>
                  <a:t> AMI </a:t>
                </a:r>
                <a:r>
                  <a:rPr lang="en-US"/>
                  <a:t>in medium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756576288"/>
        <c:crosses val="autoZero"/>
        <c:crossBetween val="midCat"/>
      </c:valAx>
      <c:valAx>
        <c:axId val="756576288"/>
        <c:scaling>
          <c:orientation val="minMax"/>
          <c:max val="4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edicted amount  of AMI in medium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756576944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egendEntry>
        <c:idx val="2"/>
        <c:delete val="1"/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Residuals for Cell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Used in optimization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Ami-TK and CurveDose Resp.xlsx]Compar simulations exp '!$D$5:$G$5,'[Ami-TK and CurveDose Resp.xlsx]Compar simulations exp '!$I$5:$J$5</c:f>
              <c:numCache>
                <c:formatCode>General</c:formatCode>
                <c:ptCount val="6"/>
                <c:pt idx="0">
                  <c:v>0.67862499999999992</c:v>
                </c:pt>
                <c:pt idx="1">
                  <c:v>0.38600000000000001</c:v>
                </c:pt>
                <c:pt idx="2">
                  <c:v>1.1280833333333333</c:v>
                </c:pt>
                <c:pt idx="3">
                  <c:v>0.54050000000000009</c:v>
                </c:pt>
                <c:pt idx="4">
                  <c:v>1.2894166666666669</c:v>
                </c:pt>
                <c:pt idx="5">
                  <c:v>1.3425</c:v>
                </c:pt>
              </c:numCache>
            </c:numRef>
          </c:xVal>
          <c:yVal>
            <c:numRef>
              <c:f>'[Ami-TK and CurveDose Resp.xlsx]Compar simulations exp '!$D$9:$G$9,'[Ami-TK and CurveDose Resp.xlsx]Compar simulations exp '!$I$9:$J$9</c:f>
              <c:numCache>
                <c:formatCode>General</c:formatCode>
                <c:ptCount val="6"/>
                <c:pt idx="0">
                  <c:v>0.56152090551754297</c:v>
                </c:pt>
                <c:pt idx="1">
                  <c:v>0.54446886863810395</c:v>
                </c:pt>
                <c:pt idx="2">
                  <c:v>1.1584417239050699</c:v>
                </c:pt>
                <c:pt idx="3">
                  <c:v>0.59526881895092798</c:v>
                </c:pt>
                <c:pt idx="4">
                  <c:v>1.0934101009368999</c:v>
                </c:pt>
                <c:pt idx="5">
                  <c:v>1.06020587085737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5DD-49D2-AED6-E764716C428F}"/>
            </c:ext>
          </c:extLst>
        </c:ser>
        <c:ser>
          <c:idx val="1"/>
          <c:order val="1"/>
          <c:tx>
            <c:v>Not used for optimization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Ami-TK and CurveDose Resp.xlsx]Compar simulations exp '!$K$5:$L$5,'[Ami-TK and CurveDose Resp.xlsx]Compar simulations exp '!$N$5:$O$5</c:f>
              <c:numCache>
                <c:formatCode>General</c:formatCode>
                <c:ptCount val="4"/>
                <c:pt idx="0">
                  <c:v>2.1464166666666666</c:v>
                </c:pt>
                <c:pt idx="1">
                  <c:v>0.64016666666666655</c:v>
                </c:pt>
                <c:pt idx="2">
                  <c:v>1.6646666666666667</c:v>
                </c:pt>
                <c:pt idx="3">
                  <c:v>1.3685833333333335</c:v>
                </c:pt>
              </c:numCache>
            </c:numRef>
          </c:xVal>
          <c:yVal>
            <c:numRef>
              <c:f>'[Ami-TK and CurveDose Resp.xlsx]Compar simulations exp '!$K$9:$L$9,'[Ami-TK and CurveDose Resp.xlsx]Compar simulations exp '!$N$9:$O$9</c:f>
              <c:numCache>
                <c:formatCode>General</c:formatCode>
                <c:ptCount val="4"/>
                <c:pt idx="0">
                  <c:v>2.1733216079560602</c:v>
                </c:pt>
                <c:pt idx="1">
                  <c:v>1.11676794868326</c:v>
                </c:pt>
                <c:pt idx="2">
                  <c:v>1.90531895633598</c:v>
                </c:pt>
                <c:pt idx="3">
                  <c:v>1.84741936774843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5DD-49D2-AED6-E764716C428F}"/>
            </c:ext>
          </c:extLst>
        </c:ser>
        <c:ser>
          <c:idx val="2"/>
          <c:order val="2"/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'[Ami-TK and CurveDose Resp.xlsx]Compar simulations exp '!$R$5:$R$6</c:f>
              <c:numCache>
                <c:formatCode>General</c:formatCode>
                <c:ptCount val="2"/>
                <c:pt idx="0">
                  <c:v>0</c:v>
                </c:pt>
                <c:pt idx="1">
                  <c:v>4</c:v>
                </c:pt>
              </c:numCache>
            </c:numRef>
          </c:xVal>
          <c:yVal>
            <c:numRef>
              <c:f>'[Ami-TK and CurveDose Resp.xlsx]Compar simulations exp '!$S$5:$S$6</c:f>
              <c:numCache>
                <c:formatCode>General</c:formatCode>
                <c:ptCount val="2"/>
                <c:pt idx="0">
                  <c:v>0</c:v>
                </c:pt>
                <c:pt idx="1">
                  <c:v>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5DD-49D2-AED6-E764716C42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56576944"/>
        <c:axId val="756576288"/>
      </c:scatterChart>
      <c:valAx>
        <c:axId val="756576944"/>
        <c:scaling>
          <c:orientation val="minMax"/>
          <c:max val="3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Experimentall amount of</a:t>
                </a:r>
                <a:r>
                  <a:rPr lang="en-US" baseline="0"/>
                  <a:t> AMI </a:t>
                </a:r>
                <a:r>
                  <a:rPr lang="en-US"/>
                  <a:t>in cell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756576288"/>
        <c:crosses val="autoZero"/>
        <c:crossBetween val="midCat"/>
      </c:valAx>
      <c:valAx>
        <c:axId val="756576288"/>
        <c:scaling>
          <c:orientation val="minMax"/>
          <c:max val="3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edicted amount  of AMI in cell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756576944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egendEntry>
        <c:idx val="2"/>
        <c:delete val="1"/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Residuals</a:t>
            </a:r>
            <a:r>
              <a:rPr lang="en-US" baseline="0"/>
              <a:t> through time</a:t>
            </a:r>
            <a:endParaRPr lang="en-US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23533027830557729"/>
          <c:y val="0.211040770609319"/>
          <c:w val="0.48675210155712295"/>
          <c:h val="0.53630600358422942"/>
        </c:manualLayout>
      </c:layout>
      <c:scatterChart>
        <c:scatterStyle val="lineMarker"/>
        <c:varyColors val="0"/>
        <c:ser>
          <c:idx val="0"/>
          <c:order val="0"/>
          <c:tx>
            <c:v>Medium residuals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[Ami-TK and CurveDose Resp.xlsx]Compar simulations exp '!$D$3:$G$3,'[Ami-TK and CurveDose Resp.xlsx]Compar simulations exp '!$I$3:$L$3,'[Ami-TK and CurveDose Resp.xlsx]Compar simulations exp '!$N$3:$O$3,'[Ami-TK and CurveDose Resp.xlsx]Compar simulations exp '!$D$3:$G$3,'[Ami-TK and CurveDose Resp.xlsx]Compar simulations exp '!$I$3:$L$3,'[Ami-TK and CurveDose Resp.xlsx]Compar simulations exp '!$N$3:$O$3</c:f>
              <c:numCache>
                <c:formatCode>General</c:formatCode>
                <c:ptCount val="20"/>
                <c:pt idx="0">
                  <c:v>24</c:v>
                </c:pt>
                <c:pt idx="1">
                  <c:v>48</c:v>
                </c:pt>
                <c:pt idx="2">
                  <c:v>168</c:v>
                </c:pt>
                <c:pt idx="3">
                  <c:v>336</c:v>
                </c:pt>
                <c:pt idx="4">
                  <c:v>24</c:v>
                </c:pt>
                <c:pt idx="5">
                  <c:v>48</c:v>
                </c:pt>
                <c:pt idx="6">
                  <c:v>168</c:v>
                </c:pt>
                <c:pt idx="7">
                  <c:v>336</c:v>
                </c:pt>
                <c:pt idx="8">
                  <c:v>24</c:v>
                </c:pt>
                <c:pt idx="9">
                  <c:v>48</c:v>
                </c:pt>
                <c:pt idx="10">
                  <c:v>24</c:v>
                </c:pt>
                <c:pt idx="11">
                  <c:v>48</c:v>
                </c:pt>
                <c:pt idx="12">
                  <c:v>168</c:v>
                </c:pt>
                <c:pt idx="13">
                  <c:v>336</c:v>
                </c:pt>
                <c:pt idx="14">
                  <c:v>24</c:v>
                </c:pt>
                <c:pt idx="15">
                  <c:v>48</c:v>
                </c:pt>
                <c:pt idx="16">
                  <c:v>168</c:v>
                </c:pt>
                <c:pt idx="17">
                  <c:v>336</c:v>
                </c:pt>
                <c:pt idx="18">
                  <c:v>24</c:v>
                </c:pt>
                <c:pt idx="19">
                  <c:v>48</c:v>
                </c:pt>
              </c:numCache>
            </c:numRef>
          </c:xVal>
          <c:yVal>
            <c:numRef>
              <c:f>'[Ami-TK and CurveDose Resp.xlsx]Compar simulations exp '!$D$12:$G$12,'[Ami-TK and CurveDose Resp.xlsx]Compar simulations exp '!$I$12:$L$12,'[Ami-TK and CurveDose Resp.xlsx]Compar simulations exp '!$N$12:$O$12,'[Ami-TK and CurveDose Resp.xlsx]Compar simulations exp '!$D$22:$G$22,'[Ami-TK and CurveDose Resp.xlsx]Compar simulations exp '!$I$22:$L$22,'[Ami-TK and CurveDose Resp.xlsx]Compar simulations exp '!$N$22:$O$22</c:f>
              <c:numCache>
                <c:formatCode>0.0%</c:formatCode>
                <c:ptCount val="20"/>
                <c:pt idx="0">
                  <c:v>2.3580842058047042</c:v>
                </c:pt>
                <c:pt idx="1">
                  <c:v>1.6238481607495057</c:v>
                </c:pt>
                <c:pt idx="2">
                  <c:v>2.0135029537186666</c:v>
                </c:pt>
                <c:pt idx="3">
                  <c:v>0</c:v>
                </c:pt>
                <c:pt idx="4">
                  <c:v>0.90961395609382256</c:v>
                </c:pt>
                <c:pt idx="5">
                  <c:v>1.223105279384433</c:v>
                </c:pt>
                <c:pt idx="6">
                  <c:v>1.4458792255814543</c:v>
                </c:pt>
                <c:pt idx="7">
                  <c:v>0</c:v>
                </c:pt>
                <c:pt idx="8">
                  <c:v>0.82521756072552599</c:v>
                </c:pt>
                <c:pt idx="9">
                  <c:v>1.0164877522757625</c:v>
                </c:pt>
                <c:pt idx="10" formatCode="0.00%">
                  <c:v>0.89529477307404493</c:v>
                </c:pt>
                <c:pt idx="11" formatCode="0.00%">
                  <c:v>1.4306045590815573</c:v>
                </c:pt>
                <c:pt idx="12" formatCode="0.00%">
                  <c:v>1.2368889105834833</c:v>
                </c:pt>
                <c:pt idx="13" formatCode="0.00%">
                  <c:v>0</c:v>
                </c:pt>
                <c:pt idx="14" formatCode="0.00%">
                  <c:v>0.63655025709866964</c:v>
                </c:pt>
                <c:pt idx="15" formatCode="0.00%">
                  <c:v>0.84655286220062309</c:v>
                </c:pt>
                <c:pt idx="16" formatCode="0.00%">
                  <c:v>1.0013675467252765</c:v>
                </c:pt>
                <c:pt idx="17" formatCode="0.00%">
                  <c:v>0</c:v>
                </c:pt>
                <c:pt idx="18" formatCode="0.00%">
                  <c:v>0.57989695626745652</c:v>
                </c:pt>
                <c:pt idx="19" formatCode="0.00%">
                  <c:v>0.9162704297378693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72F-4BE3-82EF-822A8F5A8090}"/>
            </c:ext>
          </c:extLst>
        </c:ser>
        <c:ser>
          <c:idx val="1"/>
          <c:order val="1"/>
          <c:tx>
            <c:v>Cells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[Ami-TK and CurveDose Resp.xlsx]Compar simulations exp '!$D$3:$O$3</c:f>
              <c:numCache>
                <c:formatCode>General</c:formatCode>
                <c:ptCount val="12"/>
                <c:pt idx="0">
                  <c:v>24</c:v>
                </c:pt>
                <c:pt idx="1">
                  <c:v>48</c:v>
                </c:pt>
                <c:pt idx="2">
                  <c:v>168</c:v>
                </c:pt>
                <c:pt idx="3">
                  <c:v>336</c:v>
                </c:pt>
                <c:pt idx="5">
                  <c:v>24</c:v>
                </c:pt>
                <c:pt idx="6">
                  <c:v>48</c:v>
                </c:pt>
                <c:pt idx="7">
                  <c:v>168</c:v>
                </c:pt>
                <c:pt idx="8">
                  <c:v>336</c:v>
                </c:pt>
                <c:pt idx="10">
                  <c:v>24</c:v>
                </c:pt>
                <c:pt idx="11">
                  <c:v>48</c:v>
                </c:pt>
              </c:numCache>
            </c:numRef>
          </c:xVal>
          <c:yVal>
            <c:numRef>
              <c:f>'[Ami-TK and CurveDose Resp.xlsx]Compar simulations exp '!$D$13:$O$13</c:f>
              <c:numCache>
                <c:formatCode>0.0%</c:formatCode>
                <c:ptCount val="12"/>
                <c:pt idx="0">
                  <c:v>0.82743916819678476</c:v>
                </c:pt>
                <c:pt idx="1">
                  <c:v>1.4105411104614092</c:v>
                </c:pt>
                <c:pt idx="2">
                  <c:v>1.0269114786777602</c:v>
                </c:pt>
                <c:pt idx="3">
                  <c:v>1.1013299148028268</c:v>
                </c:pt>
                <c:pt idx="5">
                  <c:v>0.84798818659877184</c:v>
                </c:pt>
                <c:pt idx="6">
                  <c:v>0.78972504346917693</c:v>
                </c:pt>
                <c:pt idx="7">
                  <c:v>1.0125348175436861</c:v>
                </c:pt>
                <c:pt idx="8">
                  <c:v>1.7444956240821561</c:v>
                </c:pt>
                <c:pt idx="10">
                  <c:v>1.1445648516235363</c:v>
                </c:pt>
                <c:pt idx="11">
                  <c:v>1.349877148692757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72F-4BE3-82EF-822A8F5A8090}"/>
            </c:ext>
          </c:extLst>
        </c:ser>
        <c:ser>
          <c:idx val="2"/>
          <c:order val="2"/>
          <c:tx>
            <c:v>Plastic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[Ami-TK and CurveDose Resp.xlsx]Compar simulations exp '!$D$3:$O$3,'[Ami-TK and CurveDose Resp.xlsx]Compar simulations exp '!$D$3:$O$3</c:f>
              <c:numCache>
                <c:formatCode>General</c:formatCode>
                <c:ptCount val="24"/>
                <c:pt idx="0">
                  <c:v>24</c:v>
                </c:pt>
                <c:pt idx="1">
                  <c:v>48</c:v>
                </c:pt>
                <c:pt idx="2">
                  <c:v>168</c:v>
                </c:pt>
                <c:pt idx="3">
                  <c:v>336</c:v>
                </c:pt>
                <c:pt idx="5">
                  <c:v>24</c:v>
                </c:pt>
                <c:pt idx="6">
                  <c:v>48</c:v>
                </c:pt>
                <c:pt idx="7">
                  <c:v>168</c:v>
                </c:pt>
                <c:pt idx="8">
                  <c:v>336</c:v>
                </c:pt>
                <c:pt idx="10">
                  <c:v>24</c:v>
                </c:pt>
                <c:pt idx="11">
                  <c:v>48</c:v>
                </c:pt>
                <c:pt idx="12">
                  <c:v>24</c:v>
                </c:pt>
                <c:pt idx="13">
                  <c:v>48</c:v>
                </c:pt>
                <c:pt idx="14">
                  <c:v>168</c:v>
                </c:pt>
                <c:pt idx="15">
                  <c:v>336</c:v>
                </c:pt>
                <c:pt idx="17">
                  <c:v>24</c:v>
                </c:pt>
                <c:pt idx="18">
                  <c:v>48</c:v>
                </c:pt>
                <c:pt idx="19">
                  <c:v>168</c:v>
                </c:pt>
                <c:pt idx="20">
                  <c:v>336</c:v>
                </c:pt>
                <c:pt idx="22">
                  <c:v>24</c:v>
                </c:pt>
                <c:pt idx="23">
                  <c:v>48</c:v>
                </c:pt>
              </c:numCache>
            </c:numRef>
          </c:xVal>
          <c:yVal>
            <c:numRef>
              <c:f>'[Ami-TK and CurveDose Resp.xlsx]Compar simulations exp '!$D$14:$O$14,'[Ami-TK and CurveDose Resp.xlsx]Compar simulations exp '!$D$23:$O$23</c:f>
              <c:numCache>
                <c:formatCode>0.0%</c:formatCode>
                <c:ptCount val="24"/>
                <c:pt idx="0">
                  <c:v>0.95761226658656085</c:v>
                </c:pt>
                <c:pt idx="1">
                  <c:v>0.8243765535024441</c:v>
                </c:pt>
                <c:pt idx="2">
                  <c:v>1.0649216100130592</c:v>
                </c:pt>
                <c:pt idx="3">
                  <c:v>0.91140786187531497</c:v>
                </c:pt>
                <c:pt idx="5">
                  <c:v>1.0373801971687115</c:v>
                </c:pt>
                <c:pt idx="6">
                  <c:v>0.9655077424831513</c:v>
                </c:pt>
                <c:pt idx="7">
                  <c:v>1.3828547549791792</c:v>
                </c:pt>
                <c:pt idx="8">
                  <c:v>1.045636488092337</c:v>
                </c:pt>
                <c:pt idx="10">
                  <c:v>1.1257903282313491</c:v>
                </c:pt>
                <c:pt idx="11">
                  <c:v>1.1171301323960636</c:v>
                </c:pt>
                <c:pt idx="12" formatCode="0.00%">
                  <c:v>0.97704898431715059</c:v>
                </c:pt>
                <c:pt idx="13" formatCode="0.00%">
                  <c:v>0.90627180076594838</c:v>
                </c:pt>
                <c:pt idx="14" formatCode="0.00%">
                  <c:v>1.2268135945115477</c:v>
                </c:pt>
                <c:pt idx="15" formatCode="0.00%">
                  <c:v>0.62618050711870843</c:v>
                </c:pt>
                <c:pt idx="17" formatCode="0.00%">
                  <c:v>1.1302651791662772</c:v>
                </c:pt>
                <c:pt idx="18" formatCode="0.00%">
                  <c:v>1.0842340753933841</c:v>
                </c:pt>
                <c:pt idx="19" formatCode="0.00%">
                  <c:v>1.4401906619370686</c:v>
                </c:pt>
                <c:pt idx="20" formatCode="0.00%">
                  <c:v>0.8210477543778596</c:v>
                </c:pt>
                <c:pt idx="22" formatCode="0.00%">
                  <c:v>1.4591951410399244</c:v>
                </c:pt>
                <c:pt idx="23" formatCode="0.00%">
                  <c:v>1.38636837551052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72F-4BE3-82EF-822A8F5A8090}"/>
            </c:ext>
          </c:extLst>
        </c:ser>
        <c:ser>
          <c:idx val="3"/>
          <c:order val="3"/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'[Ami-TK and CurveDose Resp.xlsx]Compar simulations exp '!$R$9:$R$10</c:f>
              <c:numCache>
                <c:formatCode>General</c:formatCode>
                <c:ptCount val="2"/>
                <c:pt idx="0">
                  <c:v>0</c:v>
                </c:pt>
                <c:pt idx="1">
                  <c:v>400</c:v>
                </c:pt>
              </c:numCache>
            </c:numRef>
          </c:xVal>
          <c:yVal>
            <c:numRef>
              <c:f>'[Ami-TK and CurveDose Resp.xlsx]Compar simulations exp '!$S$9:$S$10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372F-4BE3-82EF-822A8F5A80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33693672"/>
        <c:axId val="1033698264"/>
      </c:scatterChart>
      <c:valAx>
        <c:axId val="10336936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dirty="0"/>
                  <a:t>Time (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33698264"/>
        <c:crosses val="autoZero"/>
        <c:crossBetween val="midCat"/>
      </c:valAx>
      <c:valAx>
        <c:axId val="10336982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dirty="0"/>
                  <a:t>Predicted  amount of AMI / Measured amount of AMI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0.0%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3369367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Residuals for Plastic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Used in optimization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('Compar simulations exp '!$D$6:$G$6,'Compar simulations exp '!$I$6:$J$6,'Compar simulations exp '!$D$17:$G$17,'Compar simulations exp '!$I$17:$L$17,'Compar simulations exp '!$N$17:$O$17)</c:f>
              <c:numCache>
                <c:formatCode>General</c:formatCode>
                <c:ptCount val="16"/>
                <c:pt idx="0">
                  <c:v>0.53333333333333321</c:v>
                </c:pt>
                <c:pt idx="1">
                  <c:v>0.60066666666666657</c:v>
                </c:pt>
                <c:pt idx="2">
                  <c:v>0.9893333333333334</c:v>
                </c:pt>
                <c:pt idx="3">
                  <c:v>0.59399999999999986</c:v>
                </c:pt>
                <c:pt idx="4">
                  <c:v>0.95866666666666667</c:v>
                </c:pt>
                <c:pt idx="5">
                  <c:v>0.99866666666666659</c:v>
                </c:pt>
                <c:pt idx="6">
                  <c:v>0.85266666666666657</c:v>
                </c:pt>
                <c:pt idx="7">
                  <c:v>0.85933333333333339</c:v>
                </c:pt>
                <c:pt idx="8">
                  <c:v>1.0919999999999999</c:v>
                </c:pt>
                <c:pt idx="9">
                  <c:v>0.6253333333333333</c:v>
                </c:pt>
                <c:pt idx="10">
                  <c:v>1.4353333333333333</c:v>
                </c:pt>
                <c:pt idx="11">
                  <c:v>1.3986666666666667</c:v>
                </c:pt>
                <c:pt idx="12">
                  <c:v>1.8113333333333332</c:v>
                </c:pt>
                <c:pt idx="13">
                  <c:v>0.92866666666666664</c:v>
                </c:pt>
                <c:pt idx="14">
                  <c:v>1.9373333333333331</c:v>
                </c:pt>
                <c:pt idx="15">
                  <c:v>1.9060000000000004</c:v>
                </c:pt>
              </c:numCache>
            </c:numRef>
          </c:xVal>
          <c:yVal>
            <c:numRef>
              <c:f>('Compar simulations exp '!$D$10:$G$10,'Compar simulations exp '!$I$10:$J$10,'Compar simulations exp '!$D$20:$G$20,'Compar simulations exp '!$I$20:$L$20,'Compar simulations exp '!$N$20:$O$20)</c:f>
              <c:numCache>
                <c:formatCode>General</c:formatCode>
                <c:ptCount val="16"/>
                <c:pt idx="0">
                  <c:v>0.51072654217949898</c:v>
                </c:pt>
                <c:pt idx="1">
                  <c:v>0.49517551647046798</c:v>
                </c:pt>
                <c:pt idx="2">
                  <c:v>1.0535624461729201</c:v>
                </c:pt>
                <c:pt idx="3">
                  <c:v>0.54137626995393695</c:v>
                </c:pt>
                <c:pt idx="4">
                  <c:v>0.99450181568573803</c:v>
                </c:pt>
                <c:pt idx="5">
                  <c:v>0.96422039882650701</c:v>
                </c:pt>
                <c:pt idx="6">
                  <c:v>0.83309710062775699</c:v>
                </c:pt>
                <c:pt idx="7">
                  <c:v>0.77878956745820505</c:v>
                </c:pt>
                <c:pt idx="8">
                  <c:v>1.33968044520661</c:v>
                </c:pt>
                <c:pt idx="9">
                  <c:v>0.391571543784899</c:v>
                </c:pt>
                <c:pt idx="10">
                  <c:v>1.6223072871633299</c:v>
                </c:pt>
                <c:pt idx="11">
                  <c:v>1.51648206011688</c:v>
                </c:pt>
                <c:pt idx="12">
                  <c:v>2.60866535232201</c:v>
                </c:pt>
                <c:pt idx="13">
                  <c:v>0.76247968123223897</c:v>
                </c:pt>
                <c:pt idx="14">
                  <c:v>2.8269473865746799</c:v>
                </c:pt>
                <c:pt idx="15">
                  <c:v>2.64241812372307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326-4FDF-9763-262E9C3F3E40}"/>
            </c:ext>
          </c:extLst>
        </c:ser>
        <c:ser>
          <c:idx val="1"/>
          <c:order val="1"/>
          <c:tx>
            <c:v>Not used for optimization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Compar simulations exp '!$K$6:$O$6</c:f>
              <c:numCache>
                <c:formatCode>General</c:formatCode>
                <c:ptCount val="5"/>
                <c:pt idx="0">
                  <c:v>1.4293333333333333</c:v>
                </c:pt>
                <c:pt idx="1">
                  <c:v>0.97133333333333327</c:v>
                </c:pt>
                <c:pt idx="3">
                  <c:v>1.5393333333333334</c:v>
                </c:pt>
                <c:pt idx="4">
                  <c:v>1.5040000000000002</c:v>
                </c:pt>
              </c:numCache>
            </c:numRef>
          </c:xVal>
          <c:yVal>
            <c:numRef>
              <c:f>('Compar simulations exp '!$K$10:$L$10,'Compar simulations exp '!$N$10:$O$10)</c:f>
              <c:numCache>
                <c:formatCode>General</c:formatCode>
                <c:ptCount val="4"/>
                <c:pt idx="0">
                  <c:v>1.9765603964502401</c:v>
                </c:pt>
                <c:pt idx="1">
                  <c:v>1.01566157543369</c:v>
                </c:pt>
                <c:pt idx="2">
                  <c:v>1.73296657859079</c:v>
                </c:pt>
                <c:pt idx="3">
                  <c:v>1.6801637191236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326-4FDF-9763-262E9C3F3E40}"/>
            </c:ext>
          </c:extLst>
        </c:ser>
        <c:ser>
          <c:idx val="2"/>
          <c:order val="2"/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Compar simulations exp '!$R$5:$R$6</c:f>
              <c:numCache>
                <c:formatCode>General</c:formatCode>
                <c:ptCount val="2"/>
                <c:pt idx="0">
                  <c:v>0</c:v>
                </c:pt>
                <c:pt idx="1">
                  <c:v>4</c:v>
                </c:pt>
              </c:numCache>
            </c:numRef>
          </c:xVal>
          <c:yVal>
            <c:numRef>
              <c:f>'Compar simulations exp '!$S$5:$S$6</c:f>
              <c:numCache>
                <c:formatCode>General</c:formatCode>
                <c:ptCount val="2"/>
                <c:pt idx="0">
                  <c:v>0</c:v>
                </c:pt>
                <c:pt idx="1">
                  <c:v>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326-4FDF-9763-262E9C3F3E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56576944"/>
        <c:axId val="756576288"/>
      </c:scatterChart>
      <c:valAx>
        <c:axId val="756576944"/>
        <c:scaling>
          <c:orientation val="minMax"/>
          <c:max val="3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Experimental amount of</a:t>
                </a:r>
                <a:r>
                  <a:rPr lang="en-US" baseline="0" dirty="0"/>
                  <a:t> AMI </a:t>
                </a:r>
                <a:r>
                  <a:rPr lang="en-US" dirty="0"/>
                  <a:t>in plastic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756576288"/>
        <c:crosses val="autoZero"/>
        <c:crossBetween val="midCat"/>
      </c:valAx>
      <c:valAx>
        <c:axId val="756576288"/>
        <c:scaling>
          <c:orientation val="minMax"/>
          <c:max val="3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Predicted amount  of AMI in plastic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756576944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egendEntry>
        <c:idx val="2"/>
        <c:delete val="1"/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84C782-4F22-4BF7-8C90-1D359CAC0551}" type="datetimeFigureOut">
              <a:rPr lang="en-CH" smtClean="0"/>
              <a:t>7/21/23</a:t>
            </a:fld>
            <a:endParaRPr lang="en-C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70457B-EF05-4196-A220-4FEFCBC35E0A}" type="slidenum">
              <a:rPr lang="en-CH" smtClean="0"/>
              <a:t>‹N°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5278030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C9FA25-48A1-4770-9731-B86428132603}" type="slidenum">
              <a:rPr lang="en-CH" smtClean="0"/>
              <a:t>3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20787548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7FF98-BAC8-C743-A5C4-EDFB8D212E1E}" type="datetimeFigureOut">
              <a:rPr lang="en-GB" smtClean="0"/>
              <a:t>21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4A31F-F005-0541-A03D-EF26A081BA2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81944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7FF98-BAC8-C743-A5C4-EDFB8D212E1E}" type="datetimeFigureOut">
              <a:rPr lang="en-GB" smtClean="0"/>
              <a:t>21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4A31F-F005-0541-A03D-EF26A081BA2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20256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7FF98-BAC8-C743-A5C4-EDFB8D212E1E}" type="datetimeFigureOut">
              <a:rPr lang="en-GB" smtClean="0"/>
              <a:t>21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4A31F-F005-0541-A03D-EF26A081BA2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77229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7FF98-BAC8-C743-A5C4-EDFB8D212E1E}" type="datetimeFigureOut">
              <a:rPr lang="en-GB" smtClean="0"/>
              <a:t>21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4A31F-F005-0541-A03D-EF26A081BA2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0091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7FF98-BAC8-C743-A5C4-EDFB8D212E1E}" type="datetimeFigureOut">
              <a:rPr lang="en-GB" smtClean="0"/>
              <a:t>21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4A31F-F005-0541-A03D-EF26A081BA2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3188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7FF98-BAC8-C743-A5C4-EDFB8D212E1E}" type="datetimeFigureOut">
              <a:rPr lang="en-GB" smtClean="0"/>
              <a:t>21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4A31F-F005-0541-A03D-EF26A081BA2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00821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7FF98-BAC8-C743-A5C4-EDFB8D212E1E}" type="datetimeFigureOut">
              <a:rPr lang="en-GB" smtClean="0"/>
              <a:t>21/07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4A31F-F005-0541-A03D-EF26A081BA2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4010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7FF98-BAC8-C743-A5C4-EDFB8D212E1E}" type="datetimeFigureOut">
              <a:rPr lang="en-GB" smtClean="0"/>
              <a:t>21/07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4A31F-F005-0541-A03D-EF26A081BA2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5025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7FF98-BAC8-C743-A5C4-EDFB8D212E1E}" type="datetimeFigureOut">
              <a:rPr lang="en-GB" smtClean="0"/>
              <a:t>21/07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4A31F-F005-0541-A03D-EF26A081BA2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857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7FF98-BAC8-C743-A5C4-EDFB8D212E1E}" type="datetimeFigureOut">
              <a:rPr lang="en-GB" smtClean="0"/>
              <a:t>21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4A31F-F005-0541-A03D-EF26A081BA2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8528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7FF98-BAC8-C743-A5C4-EDFB8D212E1E}" type="datetimeFigureOut">
              <a:rPr lang="en-GB" smtClean="0"/>
              <a:t>21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4A31F-F005-0541-A03D-EF26A081BA2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2509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F7FF98-BAC8-C743-A5C4-EDFB8D212E1E}" type="datetimeFigureOut">
              <a:rPr lang="en-GB" smtClean="0"/>
              <a:t>21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C4A31F-F005-0541-A03D-EF26A081BA2A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64737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emf"/><Relationship Id="rId3" Type="http://schemas.openxmlformats.org/officeDocument/2006/relationships/image" Target="../media/image1.emf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3" Type="http://schemas.openxmlformats.org/officeDocument/2006/relationships/image" Target="../media/image8.emf"/><Relationship Id="rId7" Type="http://schemas.openxmlformats.org/officeDocument/2006/relationships/image" Target="../media/image10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6.bin"/><Relationship Id="rId5" Type="http://schemas.openxmlformats.org/officeDocument/2006/relationships/image" Target="../media/image9.emf"/><Relationship Id="rId4" Type="http://schemas.openxmlformats.org/officeDocument/2006/relationships/oleObject" Target="../embeddings/oleObject5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13" Type="http://schemas.openxmlformats.org/officeDocument/2006/relationships/image" Target="../media/image19.jpeg"/><Relationship Id="rId3" Type="http://schemas.openxmlformats.org/officeDocument/2006/relationships/image" Target="../media/image11.emf"/><Relationship Id="rId7" Type="http://schemas.openxmlformats.org/officeDocument/2006/relationships/oleObject" Target="../embeddings/oleObject9.bin"/><Relationship Id="rId12" Type="http://schemas.openxmlformats.org/officeDocument/2006/relationships/image" Target="../media/image18.jpeg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11" Type="http://schemas.openxmlformats.org/officeDocument/2006/relationships/image" Target="../media/image17.jpeg"/><Relationship Id="rId5" Type="http://schemas.openxmlformats.org/officeDocument/2006/relationships/image" Target="../media/image12.emf"/><Relationship Id="rId10" Type="http://schemas.openxmlformats.org/officeDocument/2006/relationships/image" Target="../media/image16.jpeg"/><Relationship Id="rId4" Type="http://schemas.openxmlformats.org/officeDocument/2006/relationships/oleObject" Target="../embeddings/oleObject8.bin"/><Relationship Id="rId9" Type="http://schemas.openxmlformats.org/officeDocument/2006/relationships/image" Target="../media/image15.jpeg"/><Relationship Id="rId14" Type="http://schemas.openxmlformats.org/officeDocument/2006/relationships/image" Target="../media/image20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package" Target="../embeddings/Document_Microsoft_Word.docx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2.emf"/><Relationship Id="rId4" Type="http://schemas.openxmlformats.org/officeDocument/2006/relationships/package" Target="../embeddings/Document_Microsoft_Word1.docx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package" Target="../embeddings/Document_Microsoft_Word2.docx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4.emf"/><Relationship Id="rId4" Type="http://schemas.openxmlformats.org/officeDocument/2006/relationships/package" Target="../embeddings/Document_Microsoft_Word3.docx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2" Type="http://schemas.openxmlformats.org/officeDocument/2006/relationships/package" Target="../embeddings/Document_Microsoft_Word4.docx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3" name="Table 32">
            <a:extLst>
              <a:ext uri="{FF2B5EF4-FFF2-40B4-BE49-F238E27FC236}">
                <a16:creationId xmlns:a16="http://schemas.microsoft.com/office/drawing/2014/main" id="{0FD0B960-DDC6-41B1-B26D-B3C7F866543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84033361"/>
              </p:ext>
            </p:extLst>
          </p:nvPr>
        </p:nvGraphicFramePr>
        <p:xfrm>
          <a:off x="823571" y="3465240"/>
          <a:ext cx="2990850" cy="1844040"/>
        </p:xfrm>
        <a:graphic>
          <a:graphicData uri="http://schemas.openxmlformats.org/drawingml/2006/table">
            <a:tbl>
              <a:tblPr firstRow="1" firstCol="1" bandRow="1"/>
              <a:tblGrid>
                <a:gridCol w="1514475">
                  <a:extLst>
                    <a:ext uri="{9D8B030D-6E8A-4147-A177-3AD203B41FA5}">
                      <a16:colId xmlns:a16="http://schemas.microsoft.com/office/drawing/2014/main" val="4046245184"/>
                    </a:ext>
                  </a:extLst>
                </a:gridCol>
                <a:gridCol w="1476375">
                  <a:extLst>
                    <a:ext uri="{9D8B030D-6E8A-4147-A177-3AD203B41FA5}">
                      <a16:colId xmlns:a16="http://schemas.microsoft.com/office/drawing/2014/main" val="425270475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just" fontAlgn="base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it parameter ​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95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ase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Value ​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95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71403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 fontAlgn="base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ka</a:t>
                      </a:r>
                      <a:r>
                        <a:rPr lang="en-US" sz="550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lastic </a:t>
                      </a: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(nmoles</a:t>
                      </a:r>
                      <a:r>
                        <a:rPr lang="en-US" sz="55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1</a:t>
                      </a: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×h</a:t>
                      </a:r>
                      <a:r>
                        <a:rPr lang="en-US" sz="55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1</a:t>
                      </a: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) ​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95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ase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41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95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096979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 fontAlgn="base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kd</a:t>
                      </a:r>
                      <a:r>
                        <a:rPr lang="en-US" sz="550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lastic </a:t>
                      </a: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(nmoles</a:t>
                      </a:r>
                      <a:r>
                        <a:rPr lang="en-US" sz="55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1</a:t>
                      </a: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×h</a:t>
                      </a:r>
                      <a:r>
                        <a:rPr lang="en-US" sz="55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1</a:t>
                      </a: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) ​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95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ase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289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95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41896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 fontAlgn="base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k</a:t>
                      </a:r>
                      <a:r>
                        <a:rPr lang="en-US" sz="550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deg </a:t>
                      </a: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(nmoles</a:t>
                      </a:r>
                      <a:r>
                        <a:rPr lang="en-US" sz="55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1</a:t>
                      </a: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×h</a:t>
                      </a:r>
                      <a:r>
                        <a:rPr lang="en-US" sz="55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1</a:t>
                      </a: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) ​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95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ase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05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95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46693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 fontAlgn="base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ka</a:t>
                      </a:r>
                      <a:r>
                        <a:rPr lang="en-US" sz="550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ells </a:t>
                      </a: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(nmoles</a:t>
                      </a:r>
                      <a:r>
                        <a:rPr lang="en-US" sz="55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1</a:t>
                      </a: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×h</a:t>
                      </a:r>
                      <a:r>
                        <a:rPr lang="en-US" sz="55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1</a:t>
                      </a: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) ​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95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ase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40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95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62904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 fontAlgn="base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kd</a:t>
                      </a:r>
                      <a:r>
                        <a:rPr lang="en-US" sz="550" baseline="-25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ells </a:t>
                      </a: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(nmoles</a:t>
                      </a:r>
                      <a:r>
                        <a:rPr lang="en-US" sz="55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1</a:t>
                      </a: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×h</a:t>
                      </a:r>
                      <a:r>
                        <a:rPr lang="en-US" sz="55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1</a:t>
                      </a: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) ​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95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ase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31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9525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1578701"/>
                  </a:ext>
                </a:extLst>
              </a:tr>
            </a:tbl>
          </a:graphicData>
        </a:graphic>
      </p:graphicFrame>
      <p:grpSp>
        <p:nvGrpSpPr>
          <p:cNvPr id="34" name="Group 33">
            <a:extLst>
              <a:ext uri="{FF2B5EF4-FFF2-40B4-BE49-F238E27FC236}">
                <a16:creationId xmlns:a16="http://schemas.microsoft.com/office/drawing/2014/main" id="{E4F4E8FE-5903-468A-8E07-C842B67BC986}"/>
              </a:ext>
            </a:extLst>
          </p:cNvPr>
          <p:cNvGrpSpPr/>
          <p:nvPr/>
        </p:nvGrpSpPr>
        <p:grpSpPr>
          <a:xfrm>
            <a:off x="633071" y="604599"/>
            <a:ext cx="3932448" cy="2489878"/>
            <a:chOff x="7235763" y="764960"/>
            <a:chExt cx="3932448" cy="2489878"/>
          </a:xfrm>
        </p:grpSpPr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DD37B298-42F9-4224-A750-A186D02B17A9}"/>
                </a:ext>
              </a:extLst>
            </p:cNvPr>
            <p:cNvSpPr/>
            <p:nvPr/>
          </p:nvSpPr>
          <p:spPr>
            <a:xfrm>
              <a:off x="7334434" y="846646"/>
              <a:ext cx="1127465" cy="77617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6353F093-50FE-49E9-92BF-9D397C8AC3B2}"/>
                </a:ext>
              </a:extLst>
            </p:cNvPr>
            <p:cNvSpPr txBox="1"/>
            <p:nvPr/>
          </p:nvSpPr>
          <p:spPr>
            <a:xfrm>
              <a:off x="7464317" y="1086172"/>
              <a:ext cx="846477" cy="28098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GB" dirty="0"/>
                <a:t>Medium</a:t>
              </a: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C210E7D4-06F5-4095-9B33-DE07F990C83E}"/>
                </a:ext>
              </a:extLst>
            </p:cNvPr>
            <p:cNvSpPr/>
            <p:nvPr/>
          </p:nvSpPr>
          <p:spPr>
            <a:xfrm>
              <a:off x="9392574" y="845167"/>
              <a:ext cx="1127465" cy="77617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C742D4C1-2675-4EDC-BFF0-268FC5DA5853}"/>
                </a:ext>
              </a:extLst>
            </p:cNvPr>
            <p:cNvSpPr txBox="1"/>
            <p:nvPr/>
          </p:nvSpPr>
          <p:spPr>
            <a:xfrm>
              <a:off x="9650680" y="1070205"/>
              <a:ext cx="647417" cy="27699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GB" dirty="0"/>
                <a:t>Plastic</a:t>
              </a:r>
            </a:p>
          </p:txBody>
        </p: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CF33C873-A4DB-4AB2-8309-CBB43B229BBA}"/>
                </a:ext>
              </a:extLst>
            </p:cNvPr>
            <p:cNvCxnSpPr>
              <a:cxnSpLocks/>
            </p:cNvCxnSpPr>
            <p:nvPr/>
          </p:nvCxnSpPr>
          <p:spPr>
            <a:xfrm>
              <a:off x="8475697" y="1135723"/>
              <a:ext cx="854734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7DB6FBC4-A780-4254-B467-737CD5528E4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477486" y="1290761"/>
              <a:ext cx="826312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92E65734-CBDE-4F8B-9E1C-FCDFB3A09FB0}"/>
                </a:ext>
              </a:extLst>
            </p:cNvPr>
            <p:cNvSpPr txBox="1"/>
            <p:nvPr/>
          </p:nvSpPr>
          <p:spPr>
            <a:xfrm>
              <a:off x="8668051" y="834172"/>
              <a:ext cx="1127052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GB" sz="1400" i="1" dirty="0" err="1"/>
                <a:t>k</a:t>
              </a:r>
              <a:r>
                <a:rPr lang="en-GB" sz="1400" dirty="0" err="1"/>
                <a:t>a</a:t>
              </a:r>
              <a:r>
                <a:rPr lang="en-GB" sz="1400" baseline="-25000" dirty="0" err="1"/>
                <a:t>plastic</a:t>
              </a:r>
              <a:endParaRPr lang="en-GB" sz="1400" baseline="-25000" dirty="0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2FC2F390-E1E4-45B7-9349-B32EBC7D33C4}"/>
                </a:ext>
              </a:extLst>
            </p:cNvPr>
            <p:cNvSpPr txBox="1"/>
            <p:nvPr/>
          </p:nvSpPr>
          <p:spPr>
            <a:xfrm>
              <a:off x="8668051" y="1338201"/>
              <a:ext cx="1127052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GB" sz="1400" i="1" dirty="0" err="1"/>
                <a:t>k</a:t>
              </a:r>
              <a:r>
                <a:rPr lang="en-GB" sz="1400" dirty="0" err="1"/>
                <a:t>d</a:t>
              </a:r>
              <a:r>
                <a:rPr lang="en-GB" sz="1400" baseline="-25000" dirty="0" err="1"/>
                <a:t>plastic</a:t>
              </a:r>
              <a:endParaRPr lang="en-GB" sz="1400" baseline="-25000" dirty="0"/>
            </a:p>
          </p:txBody>
        </p:sp>
        <p:cxnSp>
          <p:nvCxnSpPr>
            <p:cNvPr id="43" name="Straight Arrow Connector 42">
              <a:extLst>
                <a:ext uri="{FF2B5EF4-FFF2-40B4-BE49-F238E27FC236}">
                  <a16:creationId xmlns:a16="http://schemas.microsoft.com/office/drawing/2014/main" id="{C400AD59-6074-486F-9AF6-68C677A06308}"/>
                </a:ext>
              </a:extLst>
            </p:cNvPr>
            <p:cNvCxnSpPr>
              <a:cxnSpLocks/>
            </p:cNvCxnSpPr>
            <p:nvPr/>
          </p:nvCxnSpPr>
          <p:spPr>
            <a:xfrm>
              <a:off x="8512687" y="1732006"/>
              <a:ext cx="879887" cy="69159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B263E18B-E16A-4E3F-9789-C70D9D41ED06}"/>
                </a:ext>
              </a:extLst>
            </p:cNvPr>
            <p:cNvSpPr txBox="1"/>
            <p:nvPr/>
          </p:nvSpPr>
          <p:spPr>
            <a:xfrm rot="2111023">
              <a:off x="8726746" y="1868454"/>
              <a:ext cx="8167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i="1" dirty="0" err="1"/>
                <a:t>k</a:t>
              </a:r>
              <a:r>
                <a:rPr lang="en-GB" sz="1400" dirty="0" err="1"/>
                <a:t>deg</a:t>
              </a:r>
              <a:endParaRPr lang="en-GB" dirty="0"/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6D4F14F3-4CBF-47F5-9DC0-EABD2EF59DD2}"/>
                </a:ext>
              </a:extLst>
            </p:cNvPr>
            <p:cNvSpPr txBox="1"/>
            <p:nvPr/>
          </p:nvSpPr>
          <p:spPr>
            <a:xfrm>
              <a:off x="9392574" y="2374907"/>
              <a:ext cx="1775637" cy="27699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GB" dirty="0"/>
                <a:t>Degraded</a:t>
              </a: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52CE24B8-4417-4591-BE2B-D676CD5EF294}"/>
                </a:ext>
              </a:extLst>
            </p:cNvPr>
            <p:cNvSpPr/>
            <p:nvPr/>
          </p:nvSpPr>
          <p:spPr>
            <a:xfrm>
              <a:off x="7235763" y="764960"/>
              <a:ext cx="3371850" cy="2489878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C69F1576-BFFC-447C-862B-009CF5A6D54F}"/>
              </a:ext>
            </a:extLst>
          </p:cNvPr>
          <p:cNvCxnSpPr>
            <a:cxnSpLocks/>
          </p:cNvCxnSpPr>
          <p:nvPr/>
        </p:nvCxnSpPr>
        <p:spPr>
          <a:xfrm flipH="1">
            <a:off x="1340986" y="1449867"/>
            <a:ext cx="0" cy="5969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DDE386FE-272C-4954-9747-53E3E3E5D62C}"/>
              </a:ext>
            </a:extLst>
          </p:cNvPr>
          <p:cNvSpPr txBox="1"/>
          <p:nvPr/>
        </p:nvSpPr>
        <p:spPr>
          <a:xfrm>
            <a:off x="1434888" y="1621664"/>
            <a:ext cx="1127052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400" i="1" dirty="0" err="1"/>
              <a:t>k</a:t>
            </a:r>
            <a:r>
              <a:rPr lang="en-GB" sz="1400" dirty="0" err="1"/>
              <a:t>a</a:t>
            </a:r>
            <a:r>
              <a:rPr lang="en-GB" sz="1400" baseline="-25000" dirty="0" err="1"/>
              <a:t>cells</a:t>
            </a:r>
            <a:endParaRPr lang="en-GB" sz="1400" baseline="-25000" dirty="0"/>
          </a:p>
        </p:txBody>
      </p: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C095C361-3265-430C-9FED-F0C8B37EF5FE}"/>
              </a:ext>
            </a:extLst>
          </p:cNvPr>
          <p:cNvCxnSpPr>
            <a:cxnSpLocks/>
          </p:cNvCxnSpPr>
          <p:nvPr/>
        </p:nvCxnSpPr>
        <p:spPr>
          <a:xfrm flipV="1">
            <a:off x="1192033" y="1458621"/>
            <a:ext cx="1" cy="5976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ADB25158-BD9D-409A-B4E0-B01A1D2CA0F3}"/>
              </a:ext>
            </a:extLst>
          </p:cNvPr>
          <p:cNvSpPr txBox="1"/>
          <p:nvPr/>
        </p:nvSpPr>
        <p:spPr>
          <a:xfrm>
            <a:off x="762902" y="1621664"/>
            <a:ext cx="1127052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sz="1400" i="1" dirty="0" err="1"/>
              <a:t>kd</a:t>
            </a:r>
            <a:r>
              <a:rPr lang="en-GB" sz="1400" baseline="-25000" dirty="0" err="1"/>
              <a:t>cells</a:t>
            </a:r>
            <a:endParaRPr lang="en-GB" sz="1400" baseline="-250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FC4FE2A-6F75-4FED-BB38-3A3D11C7C93C}"/>
              </a:ext>
            </a:extLst>
          </p:cNvPr>
          <p:cNvSpPr txBox="1"/>
          <p:nvPr/>
        </p:nvSpPr>
        <p:spPr>
          <a:xfrm>
            <a:off x="493155" y="218880"/>
            <a:ext cx="24768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 A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B9F94C8F-C4AB-4366-8518-35E4AD6D6F4E}"/>
              </a:ext>
            </a:extLst>
          </p:cNvPr>
          <p:cNvSpPr/>
          <p:nvPr/>
        </p:nvSpPr>
        <p:spPr>
          <a:xfrm>
            <a:off x="746902" y="2046767"/>
            <a:ext cx="1127465" cy="776177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0FB4BD6-352B-4D47-855E-DA6779F52B2D}"/>
              </a:ext>
            </a:extLst>
          </p:cNvPr>
          <p:cNvSpPr txBox="1"/>
          <p:nvPr/>
        </p:nvSpPr>
        <p:spPr>
          <a:xfrm>
            <a:off x="1069304" y="2277541"/>
            <a:ext cx="846477" cy="28098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GB" dirty="0"/>
              <a:t>Cells</a:t>
            </a:r>
          </a:p>
        </p:txBody>
      </p:sp>
      <p:grpSp>
        <p:nvGrpSpPr>
          <p:cNvPr id="54" name="Groupe 1">
            <a:extLst>
              <a:ext uri="{FF2B5EF4-FFF2-40B4-BE49-F238E27FC236}">
                <a16:creationId xmlns:a16="http://schemas.microsoft.com/office/drawing/2014/main" id="{939796CA-06B5-447E-BA1B-72A011DF0474}"/>
              </a:ext>
            </a:extLst>
          </p:cNvPr>
          <p:cNvGrpSpPr/>
          <p:nvPr/>
        </p:nvGrpSpPr>
        <p:grpSpPr>
          <a:xfrm>
            <a:off x="-78082" y="5825976"/>
            <a:ext cx="6540985" cy="1759665"/>
            <a:chOff x="-207345" y="3786524"/>
            <a:chExt cx="6540985" cy="1759665"/>
          </a:xfrm>
        </p:grpSpPr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09B1E346-5499-41F0-AA2D-EF178DE0C4F1}"/>
                </a:ext>
              </a:extLst>
            </p:cNvPr>
            <p:cNvSpPr txBox="1"/>
            <p:nvPr/>
          </p:nvSpPr>
          <p:spPr>
            <a:xfrm>
              <a:off x="1714500" y="4768334"/>
              <a:ext cx="3429000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b="0" i="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 </a:t>
              </a:r>
              <a:endParaRPr lang="en-GB" dirty="0"/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D3C194B5-9951-480A-9CAC-E95F2776A9D5}"/>
                    </a:ext>
                  </a:extLst>
                </p:cNvPr>
                <p:cNvSpPr txBox="1"/>
                <p:nvPr/>
              </p:nvSpPr>
              <p:spPr>
                <a:xfrm>
                  <a:off x="-207345" y="3786524"/>
                  <a:ext cx="6540985" cy="55419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f>
                          <m:fPr>
                            <m:ctrlPr>
                              <a:rPr lang="en-GB" sz="120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fPr>
                          <m:num>
                            <m:sSub>
                              <m:sSubPr>
                                <m:ctrlPr>
                                  <a:rPr lang="en-GB" sz="1200" i="1" smtClean="0">
                                    <a:solidFill>
                                      <a:schemeClr val="tx1"/>
                                    </a:solidFill>
                                    <a:latin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r>
                                  <a:rPr lang="en-GB" sz="1200" b="0" i="1" smtClean="0">
                                    <a:solidFill>
                                      <a:schemeClr val="tx1"/>
                                    </a:solidFill>
                                    <a:latin typeface="Cambria Math" panose="02040503050406030204" pitchFamily="18" charset="0"/>
                                  </a:rPr>
                                  <m:t>𝑑𝐴</m:t>
                                </m:r>
                              </m:e>
                              <m:sub>
                                <m:r>
                                  <a:rPr lang="en-GB" sz="1200" b="0" i="1" smtClean="0">
                                    <a:solidFill>
                                      <a:schemeClr val="tx1"/>
                                    </a:solidFill>
                                    <a:latin typeface="Cambria Math" panose="02040503050406030204" pitchFamily="18" charset="0"/>
                                  </a:rPr>
                                  <m:t>𝑚𝑒𝑑𝑖𝑢𝑚</m:t>
                                </m:r>
                              </m:sub>
                            </m:sSub>
                          </m:num>
                          <m:den>
                            <m: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𝑑𝑡</m:t>
                            </m:r>
                          </m:den>
                        </m:f>
                        <m:r>
                          <a:rPr lang="en-GB" sz="1200" b="0" i="1" smtClean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  <m:t>=</m:t>
                        </m:r>
                        <m:sSub>
                          <m:sSubPr>
                            <m:ctrlP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𝐾𝑑</m:t>
                            </m:r>
                          </m:e>
                          <m:sub>
                            <m: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𝑝𝑙𝑎𝑠𝑡𝑖𝑐</m:t>
                            </m:r>
                          </m:sub>
                        </m:sSub>
                        <m:r>
                          <a:rPr lang="en-GB" sz="1200" b="0" i="1" smtClean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×</m:t>
                        </m:r>
                        <m:sSub>
                          <m:sSubPr>
                            <m:ctrlP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𝐴</m:t>
                            </m:r>
                          </m:e>
                          <m:sub>
                            <m: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𝑝𝑙𝑎𝑠𝑡𝑖𝑐</m:t>
                            </m:r>
                          </m:sub>
                        </m:sSub>
                        <m:r>
                          <a:rPr lang="en-GB" sz="1200" i="1" smtClean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  <m:t>−</m:t>
                        </m:r>
                        <m:sSub>
                          <m:sSubPr>
                            <m:ctrlPr>
                              <a:rPr lang="en-GB" sz="1200" i="1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GB" sz="1200" i="1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𝐾𝑎</m:t>
                            </m:r>
                          </m:e>
                          <m:sub>
                            <m:r>
                              <a:rPr lang="en-GB" sz="1200" i="1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𝑝𝑙𝑎𝑠𝑡𝑖𝑐</m:t>
                            </m:r>
                          </m:sub>
                        </m:sSub>
                        <m:r>
                          <a:rPr lang="en-GB" sz="1200" i="1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×</m:t>
                        </m:r>
                        <m:sSub>
                          <m:sSubPr>
                            <m:ctrlPr>
                              <a:rPr lang="en-GB" sz="120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nl-NL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𝐴</m:t>
                            </m:r>
                          </m:e>
                          <m:sub>
                            <m: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𝑚𝑒𝑑𝑖𝑢𝑚</m:t>
                            </m:r>
                          </m:sub>
                        </m:sSub>
                      </m:oMath>
                    </m:oMathPara>
                  </a14:m>
                  <a:endParaRPr lang="en-US" sz="1200" b="0" i="1" dirty="0">
                    <a:solidFill>
                      <a:schemeClr val="tx1"/>
                    </a:solidFill>
                    <a:latin typeface="Cambria Math" panose="02040503050406030204" pitchFamily="18" charset="0"/>
                    <a:ea typeface="Cambria Math" panose="02040503050406030204" pitchFamily="18" charset="0"/>
                  </a:endParaRPr>
                </a:p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GB" sz="1200" b="0" i="1" smtClean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−</m:t>
                        </m:r>
                        <m:sSub>
                          <m:sSubPr>
                            <m:ctrlP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𝐾</m:t>
                            </m:r>
                          </m:e>
                          <m:sub>
                            <m: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𝑑𝑒𝑔</m:t>
                            </m:r>
                          </m:sub>
                        </m:sSub>
                        <m:r>
                          <a:rPr lang="en-GB" sz="1200" b="0" i="1" smtClean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×</m:t>
                        </m:r>
                        <m:sSub>
                          <m:sSubPr>
                            <m:ctrlP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𝐴</m:t>
                            </m:r>
                          </m:e>
                          <m:sub>
                            <m:eqArr>
                              <m:eqArrPr>
                                <m:ctrlPr>
                                  <a:rPr lang="en-GB" sz="1200" b="0" i="1" smtClean="0">
                                    <a:solidFill>
                                      <a:schemeClr val="tx1"/>
                                    </a:solidFill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</m:ctrlPr>
                              </m:eqArrPr>
                              <m:e>
                                <m:r>
                                  <a:rPr lang="en-GB" sz="1200" b="0" i="1" smtClean="0">
                                    <a:solidFill>
                                      <a:schemeClr val="tx1"/>
                                    </a:solidFill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    </m:t>
                                </m:r>
                              </m:e>
                              <m:e>
                                <m:r>
                                  <a:rPr lang="en-GB" sz="1200" b="0" i="1" smtClean="0">
                                    <a:solidFill>
                                      <a:schemeClr val="tx1"/>
                                    </a:solidFill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𝑚𝑒𝑑𝑖𝑢𝑚</m:t>
                                </m:r>
                              </m:e>
                            </m:eqArr>
                          </m:sub>
                        </m:sSub>
                        <m:r>
                          <a:rPr lang="en-GB" sz="1200" i="1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  <m:t>−</m:t>
                        </m:r>
                        <m:sSub>
                          <m:sSubPr>
                            <m:ctrlPr>
                              <a:rPr lang="en-GB" sz="1200" i="1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GB" sz="1200" i="1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𝐾𝑑</m:t>
                            </m:r>
                          </m:e>
                          <m:sub>
                            <m:r>
                              <a:rPr lang="en-GB" sz="1200" i="1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𝑐𝑒𝑙𝑙𝑠</m:t>
                            </m:r>
                          </m:sub>
                        </m:sSub>
                        <m:r>
                          <a:rPr lang="en-GB" sz="1200" i="1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×</m:t>
                        </m:r>
                        <m:sSub>
                          <m:sSubPr>
                            <m:ctrlPr>
                              <a:rPr lang="en-GB" sz="1200" i="1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𝐴</m:t>
                            </m:r>
                          </m:e>
                          <m:sub>
                            <m:r>
                              <a:rPr lang="en-GB" sz="1200" i="1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𝑐𝑒𝑙𝑙𝑠</m:t>
                            </m:r>
                          </m:sub>
                        </m:sSub>
                        <m:r>
                          <a:rPr lang="en-GB" sz="1200" i="1" smtClean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+</m:t>
                        </m:r>
                        <m:sSub>
                          <m:sSubPr>
                            <m:ctrlPr>
                              <a:rPr lang="en-GB" sz="1200" i="1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GB" sz="1200" i="1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𝐾𝑎</m:t>
                            </m:r>
                          </m:e>
                          <m:sub>
                            <m: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𝑐𝑒𝑙𝑙𝑠</m:t>
                            </m:r>
                          </m:sub>
                        </m:sSub>
                        <m:r>
                          <a:rPr lang="en-GB" sz="1200" i="1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×</m:t>
                        </m:r>
                        <m:sSub>
                          <m:sSubPr>
                            <m:ctrlPr>
                              <a:rPr lang="en-GB" sz="1200" i="1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𝐴</m:t>
                            </m:r>
                          </m:e>
                          <m:sub>
                            <m:r>
                              <a:rPr lang="en-GB" sz="1200" i="1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𝑚𝑒𝑑𝑖𝑢𝑚</m:t>
                            </m:r>
                          </m:sub>
                        </m:sSub>
                      </m:oMath>
                    </m:oMathPara>
                  </a14:m>
                  <a:endParaRPr lang="en-GB" sz="1200" dirty="0">
                    <a:solidFill>
                      <a:schemeClr val="tx1"/>
                    </a:solidFill>
                  </a:endParaRPr>
                </a:p>
              </p:txBody>
            </p:sp>
          </mc:Choice>
          <mc:Fallback xmlns=""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D3C194B5-9951-480A-9CAC-E95F2776A9D5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-207345" y="3786524"/>
                  <a:ext cx="6540985" cy="554191"/>
                </a:xfrm>
                <a:prstGeom prst="rect">
                  <a:avLst/>
                </a:prstGeom>
                <a:blipFill>
                  <a:blip r:embed="rId2"/>
                  <a:stretch>
                    <a:fillRect b="-6667"/>
                  </a:stretch>
                </a:blipFill>
              </p:spPr>
              <p:txBody>
                <a:bodyPr/>
                <a:lstStyle/>
                <a:p>
                  <a:r>
                    <a:rPr lang="en-GB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C057ACB9-A2A6-4DE5-B494-E96F33B8D1DE}"/>
                    </a:ext>
                  </a:extLst>
                </p:cNvPr>
                <p:cNvSpPr txBox="1"/>
                <p:nvPr/>
              </p:nvSpPr>
              <p:spPr>
                <a:xfrm>
                  <a:off x="572562" y="4583475"/>
                  <a:ext cx="3698833" cy="35541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f>
                          <m:fPr>
                            <m:ctrlPr>
                              <a:rPr lang="en-GB" sz="120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fPr>
                          <m:num>
                            <m:sSub>
                              <m:sSubPr>
                                <m:ctrlPr>
                                  <a:rPr lang="en-GB" sz="1200" i="1" smtClean="0">
                                    <a:solidFill>
                                      <a:schemeClr val="tx1"/>
                                    </a:solidFill>
                                    <a:latin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r>
                                  <a:rPr lang="en-GB" sz="1200" b="0" i="1" smtClean="0">
                                    <a:solidFill>
                                      <a:schemeClr val="tx1"/>
                                    </a:solidFill>
                                    <a:latin typeface="Cambria Math" panose="02040503050406030204" pitchFamily="18" charset="0"/>
                                  </a:rPr>
                                  <m:t>𝑑𝐴</m:t>
                                </m:r>
                              </m:e>
                              <m:sub>
                                <m:r>
                                  <a:rPr lang="en-GB" sz="1200" b="0" i="1" smtClean="0">
                                    <a:solidFill>
                                      <a:schemeClr val="tx1"/>
                                    </a:solidFill>
                                    <a:latin typeface="Cambria Math" panose="02040503050406030204" pitchFamily="18" charset="0"/>
                                  </a:rPr>
                                  <m:t>𝑝𝑙𝑎𝑠𝑡𝑖𝑐</m:t>
                                </m:r>
                              </m:sub>
                            </m:sSub>
                          </m:num>
                          <m:den>
                            <m: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𝑑𝑡</m:t>
                            </m:r>
                          </m:den>
                        </m:f>
                        <m:r>
                          <a:rPr lang="en-GB" sz="1200" b="0" i="1" smtClean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  <m:t>=−</m:t>
                        </m:r>
                        <m:sSub>
                          <m:sSubPr>
                            <m:ctrlP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𝐾𝑑</m:t>
                            </m:r>
                          </m:e>
                          <m:sub>
                            <m: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𝑝𝑙𝑎𝑠𝑡𝑖𝑐</m:t>
                            </m:r>
                          </m:sub>
                        </m:sSub>
                        <m:r>
                          <a:rPr lang="en-GB" sz="1200" b="0" i="1" smtClean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×</m:t>
                        </m:r>
                        <m:sSub>
                          <m:sSubPr>
                            <m:ctrlP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𝐴</m:t>
                            </m:r>
                          </m:e>
                          <m:sub>
                            <m: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𝑝𝑙𝑎𝑠𝑡𝑖𝑐</m:t>
                            </m:r>
                          </m:sub>
                        </m:sSub>
                        <m:r>
                          <a:rPr lang="en-GB" sz="1200" b="0" i="1" smtClean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+</m:t>
                        </m:r>
                        <m:sSub>
                          <m:sSubPr>
                            <m:ctrlPr>
                              <a:rPr lang="en-GB" sz="1200" i="1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GB" sz="1200" i="1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𝐾𝑎</m:t>
                            </m:r>
                          </m:e>
                          <m:sub>
                            <m:r>
                              <a:rPr lang="en-GB" sz="1200" i="1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𝑝𝑙𝑎𝑠𝑡𝑖𝑐</m:t>
                            </m:r>
                          </m:sub>
                        </m:sSub>
                        <m:r>
                          <a:rPr lang="en-GB" sz="1200" i="1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×</m:t>
                        </m:r>
                        <m:sSub>
                          <m:sSubPr>
                            <m:ctrlPr>
                              <a:rPr lang="en-GB" sz="120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𝐴</m:t>
                            </m:r>
                          </m:e>
                          <m:sub>
                            <m: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𝑚𝑒𝑑𝑖𝑢𝑚</m:t>
                            </m:r>
                          </m:sub>
                        </m:sSub>
                      </m:oMath>
                    </m:oMathPara>
                  </a14:m>
                  <a:endParaRPr lang="en-GB" sz="1200" dirty="0">
                    <a:solidFill>
                      <a:schemeClr val="tx1"/>
                    </a:solidFill>
                  </a:endParaRPr>
                </a:p>
              </p:txBody>
            </p:sp>
          </mc:Choice>
          <mc:Fallback xmlns=""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41B4334F-A45E-437A-9434-42639C1574E1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572562" y="4583475"/>
                  <a:ext cx="3698833" cy="355418"/>
                </a:xfrm>
                <a:prstGeom prst="rect">
                  <a:avLst/>
                </a:prstGeom>
                <a:blipFill>
                  <a:blip r:embed="rId4"/>
                  <a:stretch>
                    <a:fillRect l="-494" t="-3390" b="-15254"/>
                  </a:stretch>
                </a:blipFill>
              </p:spPr>
              <p:txBody>
                <a:bodyPr/>
                <a:lstStyle/>
                <a:p>
                  <a:r>
                    <a:rPr lang="en-GB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58" name="TextBox 57">
                  <a:extLst>
                    <a:ext uri="{FF2B5EF4-FFF2-40B4-BE49-F238E27FC236}">
                      <a16:creationId xmlns:a16="http://schemas.microsoft.com/office/drawing/2014/main" id="{27112E9D-506F-432B-9C8F-3C09E5253AAD}"/>
                    </a:ext>
                  </a:extLst>
                </p:cNvPr>
                <p:cNvSpPr txBox="1"/>
                <p:nvPr/>
              </p:nvSpPr>
              <p:spPr>
                <a:xfrm>
                  <a:off x="633071" y="5195580"/>
                  <a:ext cx="3213957" cy="35060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f>
                          <m:fPr>
                            <m:ctrlPr>
                              <a:rPr lang="en-GB" sz="120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fPr>
                          <m:num>
                            <m:sSub>
                              <m:sSubPr>
                                <m:ctrlPr>
                                  <a:rPr lang="en-GB" sz="1200" i="1" smtClean="0">
                                    <a:solidFill>
                                      <a:schemeClr val="tx1"/>
                                    </a:solidFill>
                                    <a:latin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r>
                                  <a:rPr lang="en-GB" sz="1200" b="0" i="1" smtClean="0">
                                    <a:solidFill>
                                      <a:schemeClr val="tx1"/>
                                    </a:solidFill>
                                    <a:latin typeface="Cambria Math" panose="02040503050406030204" pitchFamily="18" charset="0"/>
                                  </a:rPr>
                                  <m:t>𝑑𝐴</m:t>
                                </m:r>
                              </m:e>
                              <m:sub>
                                <m:r>
                                  <a:rPr lang="en-GB" sz="1200" b="0" i="1" smtClean="0">
                                    <a:solidFill>
                                      <a:schemeClr val="tx1"/>
                                    </a:solidFill>
                                    <a:latin typeface="Cambria Math" panose="02040503050406030204" pitchFamily="18" charset="0"/>
                                  </a:rPr>
                                  <m:t>𝑐𝑒𝑙𝑙𝑠</m:t>
                                </m:r>
                              </m:sub>
                            </m:sSub>
                          </m:num>
                          <m:den>
                            <m: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𝑑𝑡</m:t>
                            </m:r>
                          </m:den>
                        </m:f>
                        <m:r>
                          <a:rPr lang="en-GB" sz="1200" b="0" i="1" smtClean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</a:rPr>
                          <m:t>=−</m:t>
                        </m:r>
                        <m:sSub>
                          <m:sSubPr>
                            <m:ctrlP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𝐾𝑑</m:t>
                            </m:r>
                          </m:e>
                          <m:sub>
                            <m: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𝑐𝑒𝑙𝑙𝑠</m:t>
                            </m:r>
                          </m:sub>
                        </m:sSub>
                        <m:r>
                          <a:rPr lang="en-GB" sz="1200" b="0" i="1" smtClean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×</m:t>
                        </m:r>
                        <m:sSub>
                          <m:sSubPr>
                            <m:ctrlP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𝐴</m:t>
                            </m:r>
                          </m:e>
                          <m:sub>
                            <m: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𝑐𝑒𝑙𝑙𝑠</m:t>
                            </m:r>
                          </m:sub>
                        </m:sSub>
                        <m:r>
                          <a:rPr lang="en-GB" sz="1200" b="0" i="1" smtClean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+</m:t>
                        </m:r>
                        <m:sSub>
                          <m:sSubPr>
                            <m:ctrlPr>
                              <a:rPr lang="en-GB" sz="120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GB" sz="1200" i="1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𝐾𝑎</m:t>
                            </m:r>
                          </m:e>
                          <m:sub>
                            <m: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</a:rPr>
                              <m:t>𝑐𝑒𝑙𝑙𝑠</m:t>
                            </m:r>
                          </m:sub>
                        </m:sSub>
                        <m:r>
                          <a:rPr lang="en-GB" sz="1200" i="1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×</m:t>
                        </m:r>
                        <m:sSub>
                          <m:sSubPr>
                            <m:ctrlPr>
                              <a:rPr lang="en-GB" sz="120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𝐴</m:t>
                            </m:r>
                          </m:e>
                          <m:sub>
                            <m:r>
                              <a:rPr lang="en-GB" sz="1200" b="0" i="1" smtClean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𝑚𝑒𝑑𝑖𝑢𝑚</m:t>
                            </m:r>
                          </m:sub>
                        </m:sSub>
                      </m:oMath>
                    </m:oMathPara>
                  </a14:m>
                  <a:endParaRPr lang="en-GB" sz="1200" dirty="0">
                    <a:solidFill>
                      <a:schemeClr val="tx1"/>
                    </a:solidFill>
                  </a:endParaRPr>
                </a:p>
              </p:txBody>
            </p:sp>
          </mc:Choice>
          <mc:Fallback xmlns=""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4D624B59-7D08-4D9D-BEFC-AF69FC6AC48F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33071" y="5195580"/>
                  <a:ext cx="3213957" cy="350609"/>
                </a:xfrm>
                <a:prstGeom prst="rect">
                  <a:avLst/>
                </a:prstGeom>
                <a:blipFill>
                  <a:blip r:embed="rId5"/>
                  <a:stretch>
                    <a:fillRect b="-13793"/>
                  </a:stretch>
                </a:blipFill>
              </p:spPr>
              <p:txBody>
                <a:bodyPr/>
                <a:lstStyle/>
                <a:p>
                  <a:r>
                    <a:rPr lang="en-GB">
                      <a:noFill/>
                    </a:rPr>
                    <a:t> </a:t>
                  </a:r>
                </a:p>
              </p:txBody>
            </p:sp>
          </mc:Fallback>
        </mc:AlternateContent>
      </p:grpSp>
      <p:sp>
        <p:nvSpPr>
          <p:cNvPr id="59" name="TextBox 58">
            <a:extLst>
              <a:ext uri="{FF2B5EF4-FFF2-40B4-BE49-F238E27FC236}">
                <a16:creationId xmlns:a16="http://schemas.microsoft.com/office/drawing/2014/main" id="{E17EBF83-5C2F-4CB1-9015-EC931D2C3CF8}"/>
              </a:ext>
            </a:extLst>
          </p:cNvPr>
          <p:cNvSpPr txBox="1"/>
          <p:nvPr/>
        </p:nvSpPr>
        <p:spPr>
          <a:xfrm>
            <a:off x="493155" y="3278810"/>
            <a:ext cx="24768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B 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D59B25AC-75BD-4E70-B14E-EB5C8C319FBF}"/>
              </a:ext>
            </a:extLst>
          </p:cNvPr>
          <p:cNvSpPr txBox="1"/>
          <p:nvPr/>
        </p:nvSpPr>
        <p:spPr>
          <a:xfrm>
            <a:off x="583880" y="5724166"/>
            <a:ext cx="24768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C 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E94B2436-3B3A-4E45-B98D-0AF45F808DE3}"/>
              </a:ext>
            </a:extLst>
          </p:cNvPr>
          <p:cNvSpPr txBox="1"/>
          <p:nvPr/>
        </p:nvSpPr>
        <p:spPr>
          <a:xfrm>
            <a:off x="279400" y="8188573"/>
            <a:ext cx="6388100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/>
              <a:t>Suppl. Fig. 1 </a:t>
            </a:r>
            <a:r>
              <a:rPr lang="en-GB" sz="1100" b="1" dirty="0">
                <a:effectLst/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Compartmental model </a:t>
            </a:r>
            <a:r>
              <a:rPr lang="en-GB" sz="1100" b="1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developed to simulate the distribution of AMI in the BS </a:t>
            </a:r>
            <a:r>
              <a:rPr lang="en-GB" sz="1100" b="1" i="1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in vitro </a:t>
            </a:r>
            <a:r>
              <a:rPr lang="en-GB" sz="1100" b="1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system after </a:t>
            </a:r>
            <a:r>
              <a:rPr lang="en-GB" sz="1100" b="1" dirty="0">
                <a:effectLst/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repeated exposure.</a:t>
            </a:r>
            <a:r>
              <a:rPr lang="en-GB" sz="1100" dirty="0">
                <a:effectLst/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 (A) Conceptual representation of the compartments and mass transfer in the model. (B) </a:t>
            </a:r>
            <a:r>
              <a:rPr lang="en-GB" altLang="nl-NL" sz="1100" dirty="0">
                <a:latin typeface="Calibri" panose="020F0502020204030204" pitchFamily="34" charset="0"/>
                <a:cs typeface="Calibri" panose="020F0502020204030204" pitchFamily="34" charset="0"/>
              </a:rPr>
              <a:t>Fit parameters used in biokinetic </a:t>
            </a:r>
            <a:r>
              <a:rPr lang="en-GB" altLang="nl-NL" sz="1100" i="1" dirty="0">
                <a:latin typeface="Calibri" panose="020F0502020204030204" pitchFamily="34" charset="0"/>
                <a:cs typeface="Calibri" panose="020F0502020204030204" pitchFamily="34" charset="0"/>
              </a:rPr>
              <a:t>in silico </a:t>
            </a:r>
            <a:r>
              <a:rPr lang="en-GB" altLang="nl-NL" sz="1100" dirty="0">
                <a:latin typeface="Calibri" panose="020F0502020204030204" pitchFamily="34" charset="0"/>
                <a:cs typeface="Calibri" panose="020F0502020204030204" pitchFamily="34" charset="0"/>
              </a:rPr>
              <a:t>model for AMI exposure in BS cultures and respective no -cells controls. These parameters were fit by minimization of RMSE using BFGS algorithm  implemented through </a:t>
            </a:r>
            <a:r>
              <a:rPr lang="en-GB" altLang="nl-NL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optim</a:t>
            </a:r>
            <a:r>
              <a:rPr lang="en-GB" altLang="nl-NL" sz="1100" dirty="0">
                <a:latin typeface="Calibri" panose="020F0502020204030204" pitchFamily="34" charset="0"/>
                <a:cs typeface="Calibri" panose="020F0502020204030204" pitchFamily="34" charset="0"/>
              </a:rPr>
              <a:t> function in  R. </a:t>
            </a:r>
            <a:r>
              <a:rPr lang="en-GB" sz="1100" dirty="0">
                <a:effectLst/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 (C</a:t>
            </a:r>
            <a:r>
              <a:rPr lang="en-GB" sz="11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) Differential equations used to simulate the mass transfer of amiodarone between medium, plastic and cells and respective parameters and constants: A</a:t>
            </a:r>
            <a:r>
              <a:rPr lang="en-GB" sz="1100" baseline="-250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plastic </a:t>
            </a:r>
            <a:r>
              <a:rPr lang="en-GB" sz="11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= amount in plastic (</a:t>
            </a:r>
            <a:r>
              <a:rPr lang="en-GB" sz="1100" dirty="0" err="1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nmoles</a:t>
            </a:r>
            <a:r>
              <a:rPr lang="en-GB" sz="11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GB" sz="1100" dirty="0" err="1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100" baseline="-25000" dirty="0" err="1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medium</a:t>
            </a:r>
            <a:r>
              <a:rPr lang="en-GB" sz="1100" baseline="-250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= amount in medium (</a:t>
            </a:r>
            <a:r>
              <a:rPr lang="en-GB" sz="1100" dirty="0" err="1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nmoles</a:t>
            </a:r>
            <a:r>
              <a:rPr lang="en-GB" sz="11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GB" sz="1100" dirty="0" err="1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GB" sz="1100" baseline="-25000" dirty="0" err="1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GB" sz="11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=rate constant of irreversible loss process (nmoles</a:t>
            </a:r>
            <a:r>
              <a:rPr lang="en-GB" sz="1100" baseline="300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-1 </a:t>
            </a:r>
            <a:r>
              <a:rPr lang="en-GB" sz="11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× h</a:t>
            </a:r>
            <a:r>
              <a:rPr lang="en-GB" sz="1100" baseline="300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GB" sz="11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GB" sz="1100" dirty="0" err="1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ka</a:t>
            </a:r>
            <a:r>
              <a:rPr lang="en-GB" sz="1100" baseline="-25000" dirty="0" err="1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plasti</a:t>
            </a:r>
            <a:r>
              <a:rPr lang="en-GB" sz="1100" dirty="0" err="1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1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 = rate constant of sorption to plastic (nmoles</a:t>
            </a:r>
            <a:r>
              <a:rPr lang="en-GB" sz="1100" baseline="300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GB" sz="11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×h</a:t>
            </a:r>
            <a:r>
              <a:rPr lang="en-GB" sz="1100" baseline="300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GB" sz="11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GB" sz="1100" dirty="0" err="1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kd</a:t>
            </a:r>
            <a:r>
              <a:rPr lang="en-GB" sz="1100" baseline="-25000" dirty="0" err="1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plastic</a:t>
            </a:r>
            <a:r>
              <a:rPr lang="en-GB" sz="1100" baseline="-250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= rate constant of desorption from plastic (nmoles</a:t>
            </a:r>
            <a:r>
              <a:rPr lang="en-GB" sz="1100" baseline="300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-1 </a:t>
            </a:r>
            <a:r>
              <a:rPr lang="en-GB" sz="11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× h</a:t>
            </a:r>
            <a:r>
              <a:rPr lang="en-GB" sz="1100" baseline="300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GB" sz="1100" dirty="0">
                <a:latin typeface="Calibri" panose="020F0502020204030204" pitchFamily="34" charset="0"/>
                <a:ea typeface="Times" panose="02020603050405020304" pitchFamily="18" charset="0"/>
                <a:cs typeface="Times New Roman" panose="02020603050405020304" pitchFamily="18" charset="0"/>
              </a:rPr>
              <a:t>).</a:t>
            </a:r>
            <a:endParaRPr lang="en-GB" altLang="nl-NL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5271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8221100E-B1BC-4AAB-9497-8071F1F92487}"/>
              </a:ext>
            </a:extLst>
          </p:cNvPr>
          <p:cNvSpPr txBox="1"/>
          <p:nvPr/>
        </p:nvSpPr>
        <p:spPr>
          <a:xfrm>
            <a:off x="548008" y="6127268"/>
            <a:ext cx="6020157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/>
              <a:t>Suppl. Fig. 2 </a:t>
            </a:r>
            <a:r>
              <a:rPr lang="en-US" sz="1100" b="1" dirty="0"/>
              <a:t>Plots of residuals from kinetic model predictions of AMI amount in the different compartments. </a:t>
            </a:r>
            <a:r>
              <a:rPr lang="en-US" sz="1100" dirty="0"/>
              <a:t>Residuals from predictions of AMI in (A) Medium, (B) Plastic and (C) Cells. (D) Residuals of the three compartments throughout time D). </a:t>
            </a:r>
            <a:endParaRPr lang="en-GB" sz="1100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CE51B0A8-AA24-4ADF-91E0-7F3B3AACF8D5}"/>
              </a:ext>
            </a:extLst>
          </p:cNvPr>
          <p:cNvSpPr/>
          <p:nvPr/>
        </p:nvSpPr>
        <p:spPr>
          <a:xfrm>
            <a:off x="339050" y="1176167"/>
            <a:ext cx="3241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A</a:t>
            </a:r>
            <a:endParaRPr lang="en-US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10533405-0CC7-48CF-95EB-020108F72308}"/>
              </a:ext>
            </a:extLst>
          </p:cNvPr>
          <p:cNvSpPr/>
          <p:nvPr/>
        </p:nvSpPr>
        <p:spPr>
          <a:xfrm>
            <a:off x="3314163" y="1176167"/>
            <a:ext cx="3145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B</a:t>
            </a:r>
            <a:endParaRPr lang="en-US" dirty="0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32C5433C-8BDB-4028-AE71-E6ECE99966CD}"/>
              </a:ext>
            </a:extLst>
          </p:cNvPr>
          <p:cNvSpPr/>
          <p:nvPr/>
        </p:nvSpPr>
        <p:spPr>
          <a:xfrm>
            <a:off x="339050" y="3628378"/>
            <a:ext cx="3064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C</a:t>
            </a:r>
            <a:endParaRPr lang="en-US" dirty="0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EC29117A-5FFA-474F-A50C-471961BC43B7}"/>
              </a:ext>
            </a:extLst>
          </p:cNvPr>
          <p:cNvSpPr/>
          <p:nvPr/>
        </p:nvSpPr>
        <p:spPr>
          <a:xfrm>
            <a:off x="3436805" y="3642677"/>
            <a:ext cx="3305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D</a:t>
            </a:r>
            <a:endParaRPr lang="en-US" dirty="0"/>
          </a:p>
        </p:txBody>
      </p:sp>
      <p:graphicFrame>
        <p:nvGraphicFramePr>
          <p:cNvPr id="25" name="Chart 24">
            <a:extLst>
              <a:ext uri="{FF2B5EF4-FFF2-40B4-BE49-F238E27FC236}">
                <a16:creationId xmlns:a16="http://schemas.microsoft.com/office/drawing/2014/main" id="{AAC8AA26-70DF-4D69-A83E-F739B64595FA}"/>
              </a:ext>
            </a:extLst>
          </p:cNvPr>
          <p:cNvGraphicFramePr>
            <a:graphicFrameLocks/>
          </p:cNvGraphicFramePr>
          <p:nvPr/>
        </p:nvGraphicFramePr>
        <p:xfrm>
          <a:off x="216408" y="999657"/>
          <a:ext cx="3060000" cy="22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6" name="Chart 25">
            <a:extLst>
              <a:ext uri="{FF2B5EF4-FFF2-40B4-BE49-F238E27FC236}">
                <a16:creationId xmlns:a16="http://schemas.microsoft.com/office/drawing/2014/main" id="{92DF1B4D-A368-4D89-BFB2-F01CA27FC07A}"/>
              </a:ext>
            </a:extLst>
          </p:cNvPr>
          <p:cNvGraphicFramePr>
            <a:graphicFrameLocks/>
          </p:cNvGraphicFramePr>
          <p:nvPr/>
        </p:nvGraphicFramePr>
        <p:xfrm>
          <a:off x="216408" y="3590291"/>
          <a:ext cx="3060000" cy="22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8" name="Chart 27">
            <a:extLst>
              <a:ext uri="{FF2B5EF4-FFF2-40B4-BE49-F238E27FC236}">
                <a16:creationId xmlns:a16="http://schemas.microsoft.com/office/drawing/2014/main" id="{CB6553AD-A08D-4D85-9A98-FEBFE4D4D2E4}"/>
              </a:ext>
            </a:extLst>
          </p:cNvPr>
          <p:cNvGraphicFramePr>
            <a:graphicFrameLocks/>
          </p:cNvGraphicFramePr>
          <p:nvPr/>
        </p:nvGraphicFramePr>
        <p:xfrm>
          <a:off x="3314163" y="3590291"/>
          <a:ext cx="3399860" cy="22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9A62E1E3-54D7-45E7-BDA0-7FA1E909845E}"/>
              </a:ext>
            </a:extLst>
          </p:cNvPr>
          <p:cNvGraphicFramePr>
            <a:graphicFrameLocks/>
          </p:cNvGraphicFramePr>
          <p:nvPr/>
        </p:nvGraphicFramePr>
        <p:xfrm>
          <a:off x="3480391" y="1042328"/>
          <a:ext cx="3377609" cy="22320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10143090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7E6CF1C1-DC1F-244F-BB71-A120427218EF}"/>
              </a:ext>
            </a:extLst>
          </p:cNvPr>
          <p:cNvSpPr/>
          <p:nvPr/>
        </p:nvSpPr>
        <p:spPr>
          <a:xfrm>
            <a:off x="431007" y="2866445"/>
            <a:ext cx="28565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/>
              <a:t>B</a:t>
            </a:r>
            <a:endParaRPr lang="en-US" sz="1400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32520BB8-9B3B-784B-186A-3E7E4184CA3A}"/>
              </a:ext>
            </a:extLst>
          </p:cNvPr>
          <p:cNvSpPr/>
          <p:nvPr/>
        </p:nvSpPr>
        <p:spPr>
          <a:xfrm>
            <a:off x="427000" y="789474"/>
            <a:ext cx="2936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/>
              <a:t>A</a:t>
            </a:r>
            <a:endParaRPr lang="en-US" sz="1400" dirty="0"/>
          </a:p>
        </p:txBody>
      </p:sp>
      <p:sp>
        <p:nvSpPr>
          <p:cNvPr id="16" name="TextBox 41">
            <a:extLst>
              <a:ext uri="{FF2B5EF4-FFF2-40B4-BE49-F238E27FC236}">
                <a16:creationId xmlns:a16="http://schemas.microsoft.com/office/drawing/2014/main" id="{F2EF65E2-B7C6-7420-E2D7-99DE990158F0}"/>
              </a:ext>
            </a:extLst>
          </p:cNvPr>
          <p:cNvSpPr txBox="1"/>
          <p:nvPr/>
        </p:nvSpPr>
        <p:spPr>
          <a:xfrm>
            <a:off x="342361" y="7015838"/>
            <a:ext cx="6173277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/>
              <a:t>Suppl. Figure 3. </a:t>
            </a:r>
            <a:r>
              <a:rPr lang="en-US" sz="1100" b="1" dirty="0"/>
              <a:t>AMI distribution kinetics: </a:t>
            </a:r>
            <a:r>
              <a:rPr lang="en-US" sz="1100" b="1" i="1" dirty="0"/>
              <a:t>in vitro </a:t>
            </a:r>
            <a:r>
              <a:rPr lang="en-US" sz="1100" b="1" dirty="0"/>
              <a:t>experimental values and </a:t>
            </a:r>
            <a:r>
              <a:rPr lang="en-US" sz="1100" b="1" i="1" dirty="0"/>
              <a:t>in silico </a:t>
            </a:r>
            <a:r>
              <a:rPr lang="en-US" sz="1100" b="1" dirty="0"/>
              <a:t>prediction simulation. </a:t>
            </a:r>
            <a:r>
              <a:rPr lang="en-US" sz="1100" dirty="0"/>
              <a:t>(A) Relative distribution of AMI analytically quantified in the different compartments of the </a:t>
            </a:r>
            <a:r>
              <a:rPr lang="en-US" sz="1100" i="1" dirty="0"/>
              <a:t>in vitro </a:t>
            </a:r>
            <a:r>
              <a:rPr lang="en-US" sz="1100" dirty="0"/>
              <a:t>assay with BS: medium (black bars), cell lysate (grey bars) and plastic (light grey bars) after acute (1 - 48 h) and repeated treatment (168 h = 7d and 336 h = 7dW) to 2 µM, and after acute exposure to 3 µM AMI initially in medium. Dotted lines depict the concentration of AMI in the medium analytically measured at 0 h exposure. Results are reported as mean ± SD of 3</a:t>
            </a:r>
            <a:r>
              <a:rPr lang="en-US" sz="1100" dirty="0">
                <a:solidFill>
                  <a:srgbClr val="FF0000"/>
                </a:solidFill>
              </a:rPr>
              <a:t> </a:t>
            </a:r>
            <a:r>
              <a:rPr lang="en-US" sz="1100" dirty="0"/>
              <a:t>replicates. Distribution kinetic profiles of AMI experimentally measured in cell lysate (red dots), in medium (orange dots) and in the</a:t>
            </a:r>
            <a:r>
              <a:rPr lang="en-US" sz="1100" dirty="0">
                <a:solidFill>
                  <a:srgbClr val="FF0000"/>
                </a:solidFill>
              </a:rPr>
              <a:t> </a:t>
            </a:r>
            <a:r>
              <a:rPr lang="en-US" sz="1100" dirty="0"/>
              <a:t>plastic bound fraction (blue dots) of BS </a:t>
            </a:r>
            <a:r>
              <a:rPr lang="en-GB" sz="1100" dirty="0"/>
              <a:t>exposed </a:t>
            </a:r>
            <a:r>
              <a:rPr lang="en-GB" sz="1100"/>
              <a:t>to AMI (</a:t>
            </a:r>
            <a:r>
              <a:rPr lang="en-GB" sz="1100" dirty="0"/>
              <a:t>B) 2 µM and (C) 3 µM. </a:t>
            </a:r>
            <a:r>
              <a:rPr lang="en-US" sz="1100" dirty="0"/>
              <a:t>Each value is the mean ±SD of 3 replicates. Simulated concentration-time profiles</a:t>
            </a:r>
            <a:r>
              <a:rPr lang="en-US" sz="1100" dirty="0">
                <a:solidFill>
                  <a:srgbClr val="FF0000"/>
                </a:solidFill>
              </a:rPr>
              <a:t> </a:t>
            </a:r>
            <a:r>
              <a:rPr lang="en-GB" sz="1100" dirty="0"/>
              <a:t>are superimposed on experimentally measured AMI concentrations in</a:t>
            </a:r>
            <a:r>
              <a:rPr lang="en-GB" sz="1100" dirty="0">
                <a:solidFill>
                  <a:srgbClr val="FF0000"/>
                </a:solidFill>
              </a:rPr>
              <a:t> </a:t>
            </a:r>
            <a:r>
              <a:rPr lang="en-GB" sz="1100" dirty="0"/>
              <a:t>cells (red line), medium (orange line) and on plastic (blue line).</a:t>
            </a:r>
            <a:r>
              <a:rPr lang="en-GB" sz="1100" strike="sngStrike" dirty="0">
                <a:solidFill>
                  <a:srgbClr val="FF0000"/>
                </a:solidFill>
              </a:rPr>
              <a:t> </a:t>
            </a:r>
            <a:endParaRPr lang="en-US" sz="1100" strike="sngStrike" dirty="0">
              <a:solidFill>
                <a:srgbClr val="FF0000"/>
              </a:solidFill>
            </a:endParaRPr>
          </a:p>
        </p:txBody>
      </p:sp>
      <p:pic>
        <p:nvPicPr>
          <p:cNvPr id="8" name="Image 12">
            <a:extLst>
              <a:ext uri="{FF2B5EF4-FFF2-40B4-BE49-F238E27FC236}">
                <a16:creationId xmlns:a16="http://schemas.microsoft.com/office/drawing/2014/main" id="{F8AD7078-9AE8-7D45-FF19-A001F5CAC0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6032" y="789474"/>
            <a:ext cx="1843200" cy="2076971"/>
          </a:xfrm>
          <a:prstGeom prst="rect">
            <a:avLst/>
          </a:prstGeom>
        </p:spPr>
      </p:pic>
      <p:pic>
        <p:nvPicPr>
          <p:cNvPr id="10" name="Image 16">
            <a:extLst>
              <a:ext uri="{FF2B5EF4-FFF2-40B4-BE49-F238E27FC236}">
                <a16:creationId xmlns:a16="http://schemas.microsoft.com/office/drawing/2014/main" id="{0278AE2D-198B-9F3B-28E9-117CE58FB04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26"/>
          <a:stretch/>
        </p:blipFill>
        <p:spPr>
          <a:xfrm>
            <a:off x="2350407" y="800021"/>
            <a:ext cx="2632279" cy="2055876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1EBE6A9E-8BB4-8E9F-14D8-1429CF706988}"/>
              </a:ext>
            </a:extLst>
          </p:cNvPr>
          <p:cNvSpPr/>
          <p:nvPr/>
        </p:nvSpPr>
        <p:spPr>
          <a:xfrm>
            <a:off x="428426" y="4863142"/>
            <a:ext cx="28565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/>
              <a:t>C</a:t>
            </a:r>
            <a:endParaRPr lang="en-US" sz="1400" dirty="0"/>
          </a:p>
        </p:txBody>
      </p:sp>
      <p:graphicFrame>
        <p:nvGraphicFramePr>
          <p:cNvPr id="13" name="Object 9">
            <a:extLst>
              <a:ext uri="{FF2B5EF4-FFF2-40B4-BE49-F238E27FC236}">
                <a16:creationId xmlns:a16="http://schemas.microsoft.com/office/drawing/2014/main" id="{550F1539-2FC7-4976-B3CF-A5C1E2E5B360}"/>
              </a:ext>
            </a:extLst>
          </p:cNvPr>
          <p:cNvGraphicFramePr>
            <a:graphicFrameLocks/>
          </p:cNvGraphicFramePr>
          <p:nvPr/>
        </p:nvGraphicFramePr>
        <p:xfrm>
          <a:off x="315913" y="5055276"/>
          <a:ext cx="3076575" cy="19605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5244894" imgH="3677008" progId="Prism9.Document">
                  <p:embed/>
                </p:oleObj>
              </mc:Choice>
              <mc:Fallback>
                <p:oleObj name="Prism 9" r:id="rId5" imgW="5244894" imgH="3677008" progId="Prism9.Document">
                  <p:embed/>
                  <p:pic>
                    <p:nvPicPr>
                      <p:cNvPr id="13" name="Object 9">
                        <a:extLst>
                          <a:ext uri="{FF2B5EF4-FFF2-40B4-BE49-F238E27FC236}">
                            <a16:creationId xmlns:a16="http://schemas.microsoft.com/office/drawing/2014/main" id="{550F1539-2FC7-4976-B3CF-A5C1E2E5B3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15913" y="5055276"/>
                        <a:ext cx="3076575" cy="19605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FDEF31B2-25A9-49E1-A534-3D44745C4F0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27000" y="3041604"/>
          <a:ext cx="4657725" cy="1717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9910981" imgH="3657210" progId="Prism9.Document">
                  <p:embed/>
                </p:oleObj>
              </mc:Choice>
              <mc:Fallback>
                <p:oleObj name="Prism 9" r:id="rId7" imgW="9910981" imgH="3657210" progId="Prism9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FDEF31B2-25A9-49E1-A534-3D44745C4F0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27000" y="3041604"/>
                        <a:ext cx="4657725" cy="1717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00EA9AA2-0E68-DE89-3C6C-841F9C8EBE67}"/>
              </a:ext>
            </a:extLst>
          </p:cNvPr>
          <p:cNvSpPr/>
          <p:nvPr/>
        </p:nvSpPr>
        <p:spPr>
          <a:xfrm rot="16200000">
            <a:off x="80318" y="1652182"/>
            <a:ext cx="1267530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AMI (</a:t>
            </a:r>
            <a:r>
              <a:rPr lang="el-GR" sz="9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mol / well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6FFFD089-C0E0-86BE-9106-8E749D5F1BFD}"/>
              </a:ext>
            </a:extLst>
          </p:cNvPr>
          <p:cNvSpPr/>
          <p:nvPr/>
        </p:nvSpPr>
        <p:spPr>
          <a:xfrm rot="16200000">
            <a:off x="1872164" y="1695412"/>
            <a:ext cx="1267530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AMI (</a:t>
            </a:r>
            <a:r>
              <a:rPr lang="el-GR" sz="9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mol / well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53810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41">
            <a:extLst>
              <a:ext uri="{FF2B5EF4-FFF2-40B4-BE49-F238E27FC236}">
                <a16:creationId xmlns:a16="http://schemas.microsoft.com/office/drawing/2014/main" id="{A1796ACF-ADBC-1542-9E46-1EF653AAB3F5}"/>
              </a:ext>
            </a:extLst>
          </p:cNvPr>
          <p:cNvSpPr txBox="1"/>
          <p:nvPr/>
        </p:nvSpPr>
        <p:spPr>
          <a:xfrm>
            <a:off x="342361" y="6958869"/>
            <a:ext cx="6173277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/>
              <a:t>Suppl. Fig. 4 </a:t>
            </a:r>
            <a:r>
              <a:rPr lang="en-US" sz="1100" b="1" dirty="0"/>
              <a:t>AMI distribution kinetics. </a:t>
            </a:r>
            <a:r>
              <a:rPr lang="en-US" sz="1100" dirty="0"/>
              <a:t>Kinetic profile of AMI analytically determined in cell lysate(red), in medium (orange) and on plastic (blue) of BS </a:t>
            </a:r>
            <a:r>
              <a:rPr lang="en-GB" sz="1100" dirty="0"/>
              <a:t>exposed to AMI (A) 1 µM, (B) 2 µM and (C) 3 µM </a:t>
            </a:r>
            <a:r>
              <a:rPr lang="en-US" sz="1100" dirty="0"/>
              <a:t>. Each value is the mean ±SD of 3 replicates</a:t>
            </a:r>
            <a:r>
              <a:rPr lang="en-US" sz="1100" dirty="0">
                <a:cs typeface="Arial" panose="020B0604020202020204" pitchFamily="34" charset="0"/>
              </a:rPr>
              <a:t>. </a:t>
            </a:r>
            <a:endParaRPr lang="en-US" sz="1100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E0392B9-A6CC-D148-8732-F15660D39649}"/>
              </a:ext>
            </a:extLst>
          </p:cNvPr>
          <p:cNvSpPr/>
          <p:nvPr/>
        </p:nvSpPr>
        <p:spPr>
          <a:xfrm>
            <a:off x="639795" y="777768"/>
            <a:ext cx="3241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A</a:t>
            </a:r>
            <a:endParaRPr lang="en-US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B8C1133D-54FC-2442-9253-A652A805B879}"/>
              </a:ext>
            </a:extLst>
          </p:cNvPr>
          <p:cNvSpPr/>
          <p:nvPr/>
        </p:nvSpPr>
        <p:spPr>
          <a:xfrm>
            <a:off x="639795" y="2865746"/>
            <a:ext cx="3145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B</a:t>
            </a:r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E72743DC-2A69-4920-9370-14987DAD169C}"/>
              </a:ext>
            </a:extLst>
          </p:cNvPr>
          <p:cNvSpPr/>
          <p:nvPr/>
        </p:nvSpPr>
        <p:spPr>
          <a:xfrm>
            <a:off x="639795" y="4861990"/>
            <a:ext cx="3145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C</a:t>
            </a:r>
            <a:endParaRPr lang="en-US" dirty="0"/>
          </a:p>
        </p:txBody>
      </p:sp>
      <p:pic>
        <p:nvPicPr>
          <p:cNvPr id="14" name="Image 13">
            <a:extLst>
              <a:ext uri="{FF2B5EF4-FFF2-40B4-BE49-F238E27FC236}">
                <a16:creationId xmlns:a16="http://schemas.microsoft.com/office/drawing/2014/main" id="{66F48714-B7F5-901E-9F42-8FBB9994C2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8241" y="5090201"/>
            <a:ext cx="4831200" cy="1792751"/>
          </a:xfrm>
          <a:prstGeom prst="rect">
            <a:avLst/>
          </a:prstGeom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id="{92842407-D485-F5C5-CC99-0DE563F6767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8241" y="1053337"/>
            <a:ext cx="4828113" cy="1638000"/>
          </a:xfrm>
          <a:prstGeom prst="rect">
            <a:avLst/>
          </a:prstGeom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F359B426-D48D-78CE-5034-73D38AD142B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8241" y="3142528"/>
            <a:ext cx="4684940" cy="172800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D5A5BDD8-CED9-4291-B81B-CE0C0D58A6B8}"/>
              </a:ext>
            </a:extLst>
          </p:cNvPr>
          <p:cNvSpPr txBox="1"/>
          <p:nvPr/>
        </p:nvSpPr>
        <p:spPr>
          <a:xfrm rot="16200000">
            <a:off x="91871" y="1708049"/>
            <a:ext cx="1360683" cy="21544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endParaRPr lang="pt-PT" sz="800" b="1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594A5965-B583-0233-5257-AF47FD789FCE}"/>
              </a:ext>
            </a:extLst>
          </p:cNvPr>
          <p:cNvSpPr/>
          <p:nvPr/>
        </p:nvSpPr>
        <p:spPr>
          <a:xfrm rot="16200000">
            <a:off x="166001" y="1746522"/>
            <a:ext cx="1267530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AMI (</a:t>
            </a:r>
            <a:r>
              <a:rPr lang="el-GR" sz="9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mol / well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BD849FFB-E469-6748-1F67-71C29D7CABBE}"/>
              </a:ext>
            </a:extLst>
          </p:cNvPr>
          <p:cNvSpPr/>
          <p:nvPr/>
        </p:nvSpPr>
        <p:spPr>
          <a:xfrm rot="16200000">
            <a:off x="166000" y="3821520"/>
            <a:ext cx="1267530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AMI (</a:t>
            </a:r>
            <a:r>
              <a:rPr lang="el-GR" sz="9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mol / well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99DABE89-4AE1-1A29-1FC7-0EAEDAA1B902}"/>
              </a:ext>
            </a:extLst>
          </p:cNvPr>
          <p:cNvSpPr/>
          <p:nvPr/>
        </p:nvSpPr>
        <p:spPr>
          <a:xfrm rot="16200000">
            <a:off x="207696" y="5800490"/>
            <a:ext cx="1267530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AMI (</a:t>
            </a:r>
            <a:r>
              <a:rPr lang="el-GR" sz="9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mol / well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14358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41">
            <a:extLst>
              <a:ext uri="{FF2B5EF4-FFF2-40B4-BE49-F238E27FC236}">
                <a16:creationId xmlns:a16="http://schemas.microsoft.com/office/drawing/2014/main" id="{A2BB9EFD-440C-4A29-B199-D47EE99668D8}"/>
              </a:ext>
            </a:extLst>
          </p:cNvPr>
          <p:cNvSpPr txBox="1"/>
          <p:nvPr/>
        </p:nvSpPr>
        <p:spPr>
          <a:xfrm>
            <a:off x="530827" y="4804517"/>
            <a:ext cx="5258182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/>
              <a:t>Suppl. Fig. </a:t>
            </a:r>
            <a:r>
              <a:rPr lang="en-GB" sz="1100" b="1"/>
              <a:t>5 </a:t>
            </a:r>
            <a:r>
              <a:rPr lang="en-US" sz="1100" b="1" dirty="0"/>
              <a:t>AMI distribution kinetic in absence of cells. </a:t>
            </a:r>
            <a:r>
              <a:rPr lang="en-US" sz="1100" dirty="0"/>
              <a:t>(A) Relative distribution of AMI in the different compartments without cells: medium (black bars) and plastic binding (grey bars) after acute (1 - 48 h) and repeated treatment (168 h = 7d and 336 h = 7dW). Results are reported as mean ± SD of three replicates. </a:t>
            </a:r>
          </a:p>
        </p:txBody>
      </p:sp>
      <p:graphicFrame>
        <p:nvGraphicFramePr>
          <p:cNvPr id="10" name="Object 5">
            <a:extLst>
              <a:ext uri="{FF2B5EF4-FFF2-40B4-BE49-F238E27FC236}">
                <a16:creationId xmlns:a16="http://schemas.microsoft.com/office/drawing/2014/main" id="{851311DA-D73C-438A-1E0F-0A6C050E869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405063" y="2700338"/>
          <a:ext cx="1658937" cy="1863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770607" imgH="3112991" progId="Prism9.Document">
                  <p:embed/>
                </p:oleObj>
              </mc:Choice>
              <mc:Fallback>
                <p:oleObj name="Prism 9" r:id="rId2" imgW="2770607" imgH="3112991" progId="Prism9.Document">
                  <p:embed/>
                  <p:pic>
                    <p:nvPicPr>
                      <p:cNvPr id="10" name="Object 5">
                        <a:extLst>
                          <a:ext uri="{FF2B5EF4-FFF2-40B4-BE49-F238E27FC236}">
                            <a16:creationId xmlns:a16="http://schemas.microsoft.com/office/drawing/2014/main" id="{851311DA-D73C-438A-1E0F-0A6C050E869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405063" y="2700338"/>
                        <a:ext cx="1658937" cy="1863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6">
            <a:extLst>
              <a:ext uri="{FF2B5EF4-FFF2-40B4-BE49-F238E27FC236}">
                <a16:creationId xmlns:a16="http://schemas.microsoft.com/office/drawing/2014/main" id="{4E99F82D-E092-682D-28A2-D13B18838DC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284663" y="2709863"/>
          <a:ext cx="1658937" cy="1844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747927" imgH="3051804" progId="Prism9.Document">
                  <p:embed/>
                </p:oleObj>
              </mc:Choice>
              <mc:Fallback>
                <p:oleObj name="Prism 9" r:id="rId4" imgW="2747927" imgH="3051804" progId="Prism9.Document">
                  <p:embed/>
                  <p:pic>
                    <p:nvPicPr>
                      <p:cNvPr id="11" name="Object 6">
                        <a:extLst>
                          <a:ext uri="{FF2B5EF4-FFF2-40B4-BE49-F238E27FC236}">
                            <a16:creationId xmlns:a16="http://schemas.microsoft.com/office/drawing/2014/main" id="{4E99F82D-E092-682D-28A2-D13B18838DC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284663" y="2709863"/>
                        <a:ext cx="1658937" cy="1844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7">
            <a:extLst>
              <a:ext uri="{FF2B5EF4-FFF2-40B4-BE49-F238E27FC236}">
                <a16:creationId xmlns:a16="http://schemas.microsoft.com/office/drawing/2014/main" id="{7EC81370-F67D-8DDB-7189-0024B336A96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28638" y="2703513"/>
          <a:ext cx="1654175" cy="1857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770607" imgH="3106872" progId="Prism9.Document">
                  <p:embed/>
                </p:oleObj>
              </mc:Choice>
              <mc:Fallback>
                <p:oleObj name="Prism 9" r:id="rId6" imgW="2770607" imgH="3106872" progId="Prism9.Document">
                  <p:embed/>
                  <p:pic>
                    <p:nvPicPr>
                      <p:cNvPr id="12" name="Object 7">
                        <a:extLst>
                          <a:ext uri="{FF2B5EF4-FFF2-40B4-BE49-F238E27FC236}">
                            <a16:creationId xmlns:a16="http://schemas.microsoft.com/office/drawing/2014/main" id="{7EC81370-F67D-8DDB-7189-0024B336A96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28638" y="2703513"/>
                        <a:ext cx="1654175" cy="1857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3" name="Image 16">
            <a:extLst>
              <a:ext uri="{FF2B5EF4-FFF2-40B4-BE49-F238E27FC236}">
                <a16:creationId xmlns:a16="http://schemas.microsoft.com/office/drawing/2014/main" id="{EF55AD88-4B8E-6ABD-D2AD-DB9D1EE52C2D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3155" t="29535" b="66573"/>
          <a:stretch/>
        </p:blipFill>
        <p:spPr>
          <a:xfrm>
            <a:off x="2675381" y="4561114"/>
            <a:ext cx="706823" cy="80010"/>
          </a:xfrm>
          <a:prstGeom prst="rect">
            <a:avLst/>
          </a:prstGeom>
        </p:spPr>
      </p:pic>
      <p:pic>
        <p:nvPicPr>
          <p:cNvPr id="14" name="Image 16">
            <a:extLst>
              <a:ext uri="{FF2B5EF4-FFF2-40B4-BE49-F238E27FC236}">
                <a16:creationId xmlns:a16="http://schemas.microsoft.com/office/drawing/2014/main" id="{212A5037-9C25-97C6-9419-D91894F2C664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3155" t="46086" b="50022"/>
          <a:stretch/>
        </p:blipFill>
        <p:spPr>
          <a:xfrm>
            <a:off x="3342919" y="4561114"/>
            <a:ext cx="706823" cy="80010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3063E1B1-C722-D94C-FE8A-570B75406068}"/>
              </a:ext>
            </a:extLst>
          </p:cNvPr>
          <p:cNvSpPr/>
          <p:nvPr/>
        </p:nvSpPr>
        <p:spPr>
          <a:xfrm rot="16200000">
            <a:off x="110960" y="3475852"/>
            <a:ext cx="1074348" cy="18000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GB" sz="900" b="1" dirty="0"/>
              <a:t>AMI (µmol)</a:t>
            </a:r>
            <a:endParaRPr lang="en-US" sz="900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F5EF1BE5-A32B-0858-7573-C8BA1A70D4C1}"/>
              </a:ext>
            </a:extLst>
          </p:cNvPr>
          <p:cNvSpPr/>
          <p:nvPr/>
        </p:nvSpPr>
        <p:spPr>
          <a:xfrm rot="16200000">
            <a:off x="1975966" y="3475853"/>
            <a:ext cx="1074348" cy="18000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GB" sz="900" b="1" dirty="0"/>
              <a:t>AMI (µmol)</a:t>
            </a:r>
            <a:endParaRPr lang="en-US" sz="900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F490D96E-5339-3FAD-D0EF-A0BFE4127B77}"/>
              </a:ext>
            </a:extLst>
          </p:cNvPr>
          <p:cNvSpPr/>
          <p:nvPr/>
        </p:nvSpPr>
        <p:spPr>
          <a:xfrm rot="16200000">
            <a:off x="3866985" y="3475852"/>
            <a:ext cx="1074348" cy="18000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GB" sz="900" b="1" dirty="0"/>
              <a:t>AMI (µmol)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39625546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41"/>
          <p:cNvSpPr txBox="1"/>
          <p:nvPr/>
        </p:nvSpPr>
        <p:spPr>
          <a:xfrm>
            <a:off x="225401" y="4216299"/>
            <a:ext cx="64008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/>
              <a:t>Suppl. Fig. 6 Amiodarone does not seem to affect oligodendrocytes </a:t>
            </a:r>
            <a:r>
              <a:rPr lang="en-GB" sz="1100" dirty="0"/>
              <a:t>(A) Relative gene expression of </a:t>
            </a:r>
            <a:r>
              <a:rPr lang="en-GB" sz="1100" dirty="0" err="1"/>
              <a:t>oligodentrocyte</a:t>
            </a:r>
            <a:r>
              <a:rPr lang="en-GB" sz="1100" dirty="0"/>
              <a:t>- (</a:t>
            </a:r>
            <a:r>
              <a:rPr lang="en-GB" sz="1100" i="1" dirty="0"/>
              <a:t>Olig2</a:t>
            </a:r>
            <a:r>
              <a:rPr lang="en-GB" sz="1100" dirty="0"/>
              <a:t>) and myelin- (</a:t>
            </a:r>
            <a:r>
              <a:rPr lang="en-GB" sz="1100" i="1" dirty="0"/>
              <a:t>MBP</a:t>
            </a:r>
            <a:r>
              <a:rPr lang="en-GB" sz="1100" dirty="0"/>
              <a:t>)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arkers. </a:t>
            </a:r>
            <a:r>
              <a:rPr lang="en-GB" sz="1100" dirty="0"/>
              <a:t>Data are expressed as fold change to control. E</a:t>
            </a:r>
            <a:r>
              <a:rPr lang="en-US" sz="1100" dirty="0"/>
              <a:t>ach value is the mean (± SD) </a:t>
            </a:r>
            <a:r>
              <a:rPr lang="en-GB" sz="1100" dirty="0"/>
              <a:t>of 3 to 9 samples coming from 3 independent experiments. (B</a:t>
            </a:r>
            <a:r>
              <a:rPr lang="en-US" sz="1100" dirty="0"/>
              <a:t>) </a:t>
            </a:r>
            <a:r>
              <a:rPr lang="en-GB" sz="1100" dirty="0"/>
              <a:t>I</a:t>
            </a:r>
            <a:r>
              <a:rPr lang="en-GB" sz="1100" b="0" dirty="0"/>
              <a:t>mmunostaining for O4 in BS control and treated with AMI, at 48h, 7d, and 7dW; </a:t>
            </a:r>
            <a:r>
              <a:rPr lang="fr-CH" sz="1100" dirty="0" err="1"/>
              <a:t>nuclei</a:t>
            </a:r>
            <a:r>
              <a:rPr lang="fr-CH" sz="1100" dirty="0"/>
              <a:t> are </a:t>
            </a:r>
            <a:r>
              <a:rPr lang="fr-CH" sz="1100" dirty="0" err="1"/>
              <a:t>stained</a:t>
            </a:r>
            <a:r>
              <a:rPr lang="fr-CH" sz="1100" dirty="0"/>
              <a:t> </a:t>
            </a:r>
            <a:r>
              <a:rPr lang="fr-CH" sz="1100" dirty="0" err="1"/>
              <a:t>with</a:t>
            </a:r>
            <a:r>
              <a:rPr lang="fr-CH" sz="1100" dirty="0"/>
              <a:t> Hoechst (</a:t>
            </a:r>
            <a:r>
              <a:rPr lang="fr-CH" sz="1100" dirty="0" err="1"/>
              <a:t>blue</a:t>
            </a:r>
            <a:r>
              <a:rPr lang="fr-CH" sz="1100" dirty="0"/>
              <a:t>).</a:t>
            </a:r>
            <a:r>
              <a:rPr lang="en-GB" sz="1100" b="0" dirty="0"/>
              <a:t> </a:t>
            </a:r>
            <a:r>
              <a:rPr lang="en-US" sz="1100" b="0" dirty="0"/>
              <a:t>Scale bars indicate 50μm</a:t>
            </a:r>
            <a:r>
              <a:rPr lang="en-GB" sz="1100" dirty="0"/>
              <a:t>.</a:t>
            </a:r>
            <a:r>
              <a:rPr lang="en-GB" sz="1100" b="0" dirty="0"/>
              <a:t> (C) Quantification of maximum intensity of O4 immunostaining images. </a:t>
            </a:r>
            <a:r>
              <a:rPr lang="en-US" sz="1100" dirty="0"/>
              <a:t>E</a:t>
            </a:r>
            <a:r>
              <a:rPr lang="en-US" sz="1100" b="0" dirty="0"/>
              <a:t>ach value is the mean (± SD) of 3 to 5 spheres</a:t>
            </a:r>
            <a:r>
              <a:rPr lang="en-GB" sz="1100" b="0" dirty="0"/>
              <a:t>. </a:t>
            </a:r>
            <a:r>
              <a:rPr lang="nn-NO" sz="1100" dirty="0"/>
              <a:t>* p &lt; 0.05.</a:t>
            </a:r>
            <a:endParaRPr lang="en-US" sz="1100" dirty="0">
              <a:solidFill>
                <a:schemeClr val="bg1">
                  <a:lumMod val="95000"/>
                </a:schemeClr>
              </a:solidFill>
            </a:endParaRP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A0687864-84A8-457E-909B-7D199728279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76104" y="737186"/>
          <a:ext cx="1579563" cy="1189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451602" imgH="2601083" progId="Prism9.Document">
                  <p:embed/>
                </p:oleObj>
              </mc:Choice>
              <mc:Fallback>
                <p:oleObj name="Prism 9" r:id="rId2" imgW="3451602" imgH="2601083" progId="Prism9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A0687864-84A8-457E-909B-7D199728279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76104" y="737186"/>
                        <a:ext cx="1579563" cy="1189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1C524E21-88B4-4956-BD7A-FD957776F2A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59476" y="735648"/>
          <a:ext cx="1579563" cy="1190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451602" imgH="2601083" progId="Prism9.Document">
                  <p:embed/>
                </p:oleObj>
              </mc:Choice>
              <mc:Fallback>
                <p:oleObj name="Prism 9" r:id="rId4" imgW="3451602" imgH="2601083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1C524E21-88B4-4956-BD7A-FD957776F2A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359476" y="735648"/>
                        <a:ext cx="1579563" cy="1190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6" name="Group 15">
            <a:extLst>
              <a:ext uri="{FF2B5EF4-FFF2-40B4-BE49-F238E27FC236}">
                <a16:creationId xmlns:a16="http://schemas.microsoft.com/office/drawing/2014/main" id="{767F6D47-112B-4259-B981-E90E834502E6}"/>
              </a:ext>
            </a:extLst>
          </p:cNvPr>
          <p:cNvGrpSpPr/>
          <p:nvPr/>
        </p:nvGrpSpPr>
        <p:grpSpPr>
          <a:xfrm>
            <a:off x="3836833" y="1002530"/>
            <a:ext cx="593278" cy="797702"/>
            <a:chOff x="6063908" y="1939979"/>
            <a:chExt cx="730188" cy="981787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96CAF32C-DBFF-4E86-8F69-4C8D4A4245F1}"/>
                </a:ext>
              </a:extLst>
            </p:cNvPr>
            <p:cNvGrpSpPr/>
            <p:nvPr/>
          </p:nvGrpSpPr>
          <p:grpSpPr>
            <a:xfrm>
              <a:off x="6063908" y="1939979"/>
              <a:ext cx="730188" cy="267608"/>
              <a:chOff x="5896752" y="847748"/>
              <a:chExt cx="730188" cy="267608"/>
            </a:xfrm>
          </p:grpSpPr>
          <p:pic>
            <p:nvPicPr>
              <p:cNvPr id="30" name="Picture 29">
                <a:extLst>
                  <a:ext uri="{FF2B5EF4-FFF2-40B4-BE49-F238E27FC236}">
                    <a16:creationId xmlns:a16="http://schemas.microsoft.com/office/drawing/2014/main" id="{2A0F379A-4C0F-479F-BCE2-CCA62CAB98C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r="79858"/>
              <a:stretch/>
            </p:blipFill>
            <p:spPr>
              <a:xfrm>
                <a:off x="5896752" y="888553"/>
                <a:ext cx="144000" cy="144000"/>
              </a:xfrm>
              <a:prstGeom prst="rect">
                <a:avLst/>
              </a:prstGeom>
            </p:spPr>
          </p:pic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DDE9BE5A-C540-4FBC-BD7E-82E13631BDBC}"/>
                  </a:ext>
                </a:extLst>
              </p:cNvPr>
              <p:cNvSpPr txBox="1"/>
              <p:nvPr/>
            </p:nvSpPr>
            <p:spPr>
              <a:xfrm>
                <a:off x="6010992" y="847748"/>
                <a:ext cx="615948" cy="2676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13" dirty="0"/>
                  <a:t>Control</a:t>
                </a:r>
                <a:endParaRPr lang="en-CH" sz="813" dirty="0"/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CE5149B8-BEE9-40E1-AA84-3285F7912366}"/>
                </a:ext>
              </a:extLst>
            </p:cNvPr>
            <p:cNvGrpSpPr/>
            <p:nvPr/>
          </p:nvGrpSpPr>
          <p:grpSpPr>
            <a:xfrm>
              <a:off x="6063908" y="2178039"/>
              <a:ext cx="589299" cy="267608"/>
              <a:chOff x="5896752" y="1264025"/>
              <a:chExt cx="589299" cy="267608"/>
            </a:xfrm>
          </p:grpSpPr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35CCF705-B9DE-481A-97EB-FC7B8B13991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27530" r="53600"/>
              <a:stretch/>
            </p:blipFill>
            <p:spPr>
              <a:xfrm>
                <a:off x="5896752" y="1304830"/>
                <a:ext cx="144000" cy="144000"/>
              </a:xfrm>
              <a:prstGeom prst="rect">
                <a:avLst/>
              </a:prstGeom>
            </p:spPr>
          </p:pic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D56BB209-C54E-42F6-A4FB-8C4DDFD8AFCC}"/>
                  </a:ext>
                </a:extLst>
              </p:cNvPr>
              <p:cNvSpPr txBox="1"/>
              <p:nvPr/>
            </p:nvSpPr>
            <p:spPr>
              <a:xfrm>
                <a:off x="6012153" y="1264025"/>
                <a:ext cx="473898" cy="2676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13" dirty="0"/>
                  <a:t>1µM</a:t>
                </a:r>
                <a:endParaRPr lang="en-CH" sz="813" dirty="0"/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ED436827-9DCA-4327-B8D9-5A8846E371A7}"/>
                </a:ext>
              </a:extLst>
            </p:cNvPr>
            <p:cNvGrpSpPr/>
            <p:nvPr/>
          </p:nvGrpSpPr>
          <p:grpSpPr>
            <a:xfrm>
              <a:off x="6063908" y="2416099"/>
              <a:ext cx="684810" cy="267608"/>
              <a:chOff x="5896752" y="1704508"/>
              <a:chExt cx="684810" cy="267608"/>
            </a:xfrm>
          </p:grpSpPr>
          <p:pic>
            <p:nvPicPr>
              <p:cNvPr id="23" name="Picture 22">
                <a:extLst>
                  <a:ext uri="{FF2B5EF4-FFF2-40B4-BE49-F238E27FC236}">
                    <a16:creationId xmlns:a16="http://schemas.microsoft.com/office/drawing/2014/main" id="{83BF6424-F683-461F-9021-5C7FBD0D5F1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52998" r="27195"/>
              <a:stretch/>
            </p:blipFill>
            <p:spPr>
              <a:xfrm>
                <a:off x="5896752" y="1745313"/>
                <a:ext cx="144000" cy="144000"/>
              </a:xfrm>
              <a:prstGeom prst="rect">
                <a:avLst/>
              </a:prstGeom>
            </p:spPr>
          </p:pic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DD8BAB25-339A-4D59-9308-351534946239}"/>
                  </a:ext>
                </a:extLst>
              </p:cNvPr>
              <p:cNvSpPr txBox="1"/>
              <p:nvPr/>
            </p:nvSpPr>
            <p:spPr>
              <a:xfrm>
                <a:off x="6010992" y="1704508"/>
                <a:ext cx="570570" cy="2676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13" dirty="0"/>
                  <a:t>1,5µM</a:t>
                </a:r>
                <a:endParaRPr lang="en-CH" sz="813" dirty="0"/>
              </a:p>
            </p:txBody>
          </p: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F07B3509-6D9F-44F7-9FBA-38A9C41EFB85}"/>
                </a:ext>
              </a:extLst>
            </p:cNvPr>
            <p:cNvGrpSpPr/>
            <p:nvPr/>
          </p:nvGrpSpPr>
          <p:grpSpPr>
            <a:xfrm>
              <a:off x="6063908" y="2654158"/>
              <a:ext cx="588137" cy="267608"/>
              <a:chOff x="5896752" y="2201657"/>
              <a:chExt cx="588137" cy="267608"/>
            </a:xfrm>
          </p:grpSpPr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F0F824DD-81C9-40E6-8AEA-2958175CFB9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80193"/>
              <a:stretch/>
            </p:blipFill>
            <p:spPr>
              <a:xfrm>
                <a:off x="5896752" y="2242462"/>
                <a:ext cx="144000" cy="144000"/>
              </a:xfrm>
              <a:prstGeom prst="rect">
                <a:avLst/>
              </a:prstGeom>
            </p:spPr>
          </p:pic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9C1BF413-4908-4BB3-B7D3-DC25D6B87ADA}"/>
                  </a:ext>
                </a:extLst>
              </p:cNvPr>
              <p:cNvSpPr txBox="1"/>
              <p:nvPr/>
            </p:nvSpPr>
            <p:spPr>
              <a:xfrm>
                <a:off x="6010992" y="2201657"/>
                <a:ext cx="473897" cy="2676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13" dirty="0"/>
                  <a:t>2µM</a:t>
                </a:r>
                <a:endParaRPr lang="en-CH" sz="813" dirty="0"/>
              </a:p>
            </p:txBody>
          </p:sp>
        </p:grpSp>
      </p:grp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42C8EFBD-046C-4332-99D7-8134C1484DE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968267" y="2381593"/>
          <a:ext cx="2008188" cy="16208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3423885" imgH="2761266" progId="Prism9.Document">
                  <p:embed/>
                </p:oleObj>
              </mc:Choice>
              <mc:Fallback>
                <p:oleObj name="Prism 9" r:id="rId7" imgW="3423885" imgH="2761266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42C8EFBD-046C-4332-99D7-8134C1484DE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968267" y="2381593"/>
                        <a:ext cx="2008188" cy="16208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28" name="Group 127">
            <a:extLst>
              <a:ext uri="{FF2B5EF4-FFF2-40B4-BE49-F238E27FC236}">
                <a16:creationId xmlns:a16="http://schemas.microsoft.com/office/drawing/2014/main" id="{C92A058C-0C5F-4D6E-AB89-D5B5639BB8C1}"/>
              </a:ext>
            </a:extLst>
          </p:cNvPr>
          <p:cNvGrpSpPr/>
          <p:nvPr/>
        </p:nvGrpSpPr>
        <p:grpSpPr>
          <a:xfrm>
            <a:off x="775547" y="2176563"/>
            <a:ext cx="2884340" cy="1953608"/>
            <a:chOff x="8258022" y="4063492"/>
            <a:chExt cx="3549957" cy="2404440"/>
          </a:xfrm>
        </p:grpSpPr>
        <p:pic>
          <p:nvPicPr>
            <p:cNvPr id="101" name="Picture 100" descr="A picture containing tree&#10;&#10;Description automatically generated">
              <a:extLst>
                <a:ext uri="{FF2B5EF4-FFF2-40B4-BE49-F238E27FC236}">
                  <a16:creationId xmlns:a16="http://schemas.microsoft.com/office/drawing/2014/main" id="{8860F598-B086-460C-B411-49C9CB13C5E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66748" y="5387932"/>
              <a:ext cx="1080000" cy="1080000"/>
            </a:xfrm>
            <a:prstGeom prst="rect">
              <a:avLst/>
            </a:prstGeom>
          </p:spPr>
        </p:pic>
        <p:pic>
          <p:nvPicPr>
            <p:cNvPr id="103" name="Picture 102" descr="A picture containing tree, outdoor&#10;&#10;Description automatically generated">
              <a:extLst>
                <a:ext uri="{FF2B5EF4-FFF2-40B4-BE49-F238E27FC236}">
                  <a16:creationId xmlns:a16="http://schemas.microsoft.com/office/drawing/2014/main" id="{6D9C0CD9-4210-4FF1-8348-D1381EEF181A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66748" y="4264454"/>
              <a:ext cx="1080000" cy="1080000"/>
            </a:xfrm>
            <a:prstGeom prst="rect">
              <a:avLst/>
            </a:prstGeom>
          </p:spPr>
        </p:pic>
        <p:pic>
          <p:nvPicPr>
            <p:cNvPr id="109" name="Picture 108" descr="A picture containing tree, outdoor, green, crowd&#10;&#10;Description automatically generated">
              <a:extLst>
                <a:ext uri="{FF2B5EF4-FFF2-40B4-BE49-F238E27FC236}">
                  <a16:creationId xmlns:a16="http://schemas.microsoft.com/office/drawing/2014/main" id="{7AF23141-E589-4999-96B7-494CB0EEE814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95525" y="5387932"/>
              <a:ext cx="1080000" cy="1080000"/>
            </a:xfrm>
            <a:prstGeom prst="rect">
              <a:avLst/>
            </a:prstGeom>
          </p:spPr>
        </p:pic>
        <p:pic>
          <p:nvPicPr>
            <p:cNvPr id="111" name="Picture 110" descr="A picture containing grass, outdoor, light&#10;&#10;Description automatically generated">
              <a:extLst>
                <a:ext uri="{FF2B5EF4-FFF2-40B4-BE49-F238E27FC236}">
                  <a16:creationId xmlns:a16="http://schemas.microsoft.com/office/drawing/2014/main" id="{6D7FE2F1-A9EC-403A-82B4-85972D281010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95525" y="4264454"/>
              <a:ext cx="1080000" cy="1080000"/>
            </a:xfrm>
            <a:prstGeom prst="rect">
              <a:avLst/>
            </a:prstGeom>
          </p:spPr>
        </p:pic>
        <p:pic>
          <p:nvPicPr>
            <p:cNvPr id="113" name="Picture 112" descr="A picture containing tree&#10;&#10;Description automatically generated">
              <a:extLst>
                <a:ext uri="{FF2B5EF4-FFF2-40B4-BE49-F238E27FC236}">
                  <a16:creationId xmlns:a16="http://schemas.microsoft.com/office/drawing/2014/main" id="{EC6265D4-D719-4F14-85FA-07BAF53AF135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27979" y="5387932"/>
              <a:ext cx="1080000" cy="1080000"/>
            </a:xfrm>
            <a:prstGeom prst="rect">
              <a:avLst/>
            </a:prstGeom>
          </p:spPr>
        </p:pic>
        <p:pic>
          <p:nvPicPr>
            <p:cNvPr id="115" name="Picture 114" descr="A picture containing outdoor, night sky&#10;&#10;Description automatically generated">
              <a:extLst>
                <a:ext uri="{FF2B5EF4-FFF2-40B4-BE49-F238E27FC236}">
                  <a16:creationId xmlns:a16="http://schemas.microsoft.com/office/drawing/2014/main" id="{7D9AFCB7-BD23-4370-A608-402748F4879D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27979" y="4264454"/>
              <a:ext cx="1080000" cy="1080000"/>
            </a:xfrm>
            <a:prstGeom prst="rect">
              <a:avLst/>
            </a:prstGeom>
          </p:spPr>
        </p:pic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4A0FE71F-25B3-4A1E-9637-6264D7B45035}"/>
                </a:ext>
              </a:extLst>
            </p:cNvPr>
            <p:cNvSpPr txBox="1"/>
            <p:nvPr/>
          </p:nvSpPr>
          <p:spPr>
            <a:xfrm rot="16200000">
              <a:off x="7802700" y="4719776"/>
              <a:ext cx="1080000" cy="169356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94" dirty="0"/>
                <a:t>Control</a:t>
              </a:r>
              <a:endParaRPr lang="en-CH" sz="894" dirty="0"/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A8326B75-73E6-455D-9C59-990B85727055}"/>
                </a:ext>
              </a:extLst>
            </p:cNvPr>
            <p:cNvSpPr txBox="1"/>
            <p:nvPr/>
          </p:nvSpPr>
          <p:spPr>
            <a:xfrm rot="16200000">
              <a:off x="7812752" y="5843254"/>
              <a:ext cx="1080000" cy="169356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94"/>
                <a:t>1.5µM</a:t>
              </a:r>
              <a:endParaRPr lang="en-CH" sz="894" dirty="0"/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E61C39CD-12C9-418F-B4AD-ACB0D48828C6}"/>
                </a:ext>
              </a:extLst>
            </p:cNvPr>
            <p:cNvSpPr txBox="1"/>
            <p:nvPr/>
          </p:nvSpPr>
          <p:spPr>
            <a:xfrm>
              <a:off x="8466748" y="4063492"/>
              <a:ext cx="1080000" cy="169356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94" dirty="0"/>
                <a:t>48h</a:t>
              </a:r>
              <a:endParaRPr lang="en-CH" sz="894" dirty="0"/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3B31F7D1-54A6-4882-9DAD-426D116D1017}"/>
                </a:ext>
              </a:extLst>
            </p:cNvPr>
            <p:cNvSpPr txBox="1"/>
            <p:nvPr/>
          </p:nvSpPr>
          <p:spPr>
            <a:xfrm>
              <a:off x="9595525" y="4063492"/>
              <a:ext cx="1080000" cy="169356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94" dirty="0"/>
                <a:t>7d</a:t>
              </a:r>
              <a:endParaRPr lang="en-CH" sz="894" dirty="0"/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3F69E741-306D-45AE-8968-CAF6F3A2C8D2}"/>
                </a:ext>
              </a:extLst>
            </p:cNvPr>
            <p:cNvSpPr txBox="1"/>
            <p:nvPr/>
          </p:nvSpPr>
          <p:spPr>
            <a:xfrm>
              <a:off x="10727979" y="4063492"/>
              <a:ext cx="1080000" cy="169356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94" dirty="0"/>
                <a:t>7dW</a:t>
              </a:r>
              <a:endParaRPr lang="en-CH" sz="894" dirty="0"/>
            </a:p>
          </p:txBody>
        </p:sp>
      </p:grpSp>
      <p:sp>
        <p:nvSpPr>
          <p:cNvPr id="34" name="Rectangle 33">
            <a:extLst>
              <a:ext uri="{FF2B5EF4-FFF2-40B4-BE49-F238E27FC236}">
                <a16:creationId xmlns:a16="http://schemas.microsoft.com/office/drawing/2014/main" id="{7EAFC413-A0BE-3B4E-98D1-6EC657121407}"/>
              </a:ext>
            </a:extLst>
          </p:cNvPr>
          <p:cNvSpPr/>
          <p:nvPr/>
        </p:nvSpPr>
        <p:spPr>
          <a:xfrm>
            <a:off x="481877" y="655528"/>
            <a:ext cx="2936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/>
              <a:t>A</a:t>
            </a:r>
            <a:endParaRPr lang="en-US" sz="1400" dirty="0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C621B758-E6D7-2549-B393-73A89550AE76}"/>
              </a:ext>
            </a:extLst>
          </p:cNvPr>
          <p:cNvSpPr/>
          <p:nvPr/>
        </p:nvSpPr>
        <p:spPr>
          <a:xfrm>
            <a:off x="494054" y="1951506"/>
            <a:ext cx="28565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47A04B35-2D26-304D-965E-F70D46301FB1}"/>
              </a:ext>
            </a:extLst>
          </p:cNvPr>
          <p:cNvSpPr/>
          <p:nvPr/>
        </p:nvSpPr>
        <p:spPr>
          <a:xfrm>
            <a:off x="3935167" y="1951506"/>
            <a:ext cx="27924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53276332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Objet 7">
            <a:extLst>
              <a:ext uri="{FF2B5EF4-FFF2-40B4-BE49-F238E27FC236}">
                <a16:creationId xmlns:a16="http://schemas.microsoft.com/office/drawing/2014/main" id="{554C184D-05FF-DF7F-4BE4-C8FDAC252BB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02967348"/>
              </p:ext>
            </p:extLst>
          </p:nvPr>
        </p:nvGraphicFramePr>
        <p:xfrm>
          <a:off x="649432" y="1203036"/>
          <a:ext cx="6057900" cy="3987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Document" r:id="rId2" imgW="6057900" imgH="3987800" progId="Word.Document.12">
                  <p:embed/>
                </p:oleObj>
              </mc:Choice>
              <mc:Fallback>
                <p:oleObj name="Document" r:id="rId2" imgW="6057900" imgH="39878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49432" y="1203036"/>
                        <a:ext cx="6057900" cy="3987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ZoneTexte 9">
            <a:extLst>
              <a:ext uri="{FF2B5EF4-FFF2-40B4-BE49-F238E27FC236}">
                <a16:creationId xmlns:a16="http://schemas.microsoft.com/office/drawing/2014/main" id="{3726151A-6A21-45D1-14FD-104C61088502}"/>
              </a:ext>
            </a:extLst>
          </p:cNvPr>
          <p:cNvSpPr txBox="1"/>
          <p:nvPr/>
        </p:nvSpPr>
        <p:spPr>
          <a:xfrm>
            <a:off x="649432" y="873687"/>
            <a:ext cx="498244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. Table 1: 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equences of qPCR primers used with SYBR green®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nd cDNA input</a:t>
            </a:r>
            <a:endParaRPr lang="fr-CH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8975B996-D3A7-F8EC-971B-D6B0120DFE2D}"/>
              </a:ext>
            </a:extLst>
          </p:cNvPr>
          <p:cNvSpPr txBox="1"/>
          <p:nvPr/>
        </p:nvSpPr>
        <p:spPr>
          <a:xfrm>
            <a:off x="697043" y="5522704"/>
            <a:ext cx="365760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. Table 2: </a:t>
            </a:r>
            <a:r>
              <a:rPr lang="en-GB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ferences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or TaqMan® assays and cDNA input</a:t>
            </a:r>
            <a:endParaRPr lang="fr-CH" sz="10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Objet 2">
            <a:extLst>
              <a:ext uri="{FF2B5EF4-FFF2-40B4-BE49-F238E27FC236}">
                <a16:creationId xmlns:a16="http://schemas.microsoft.com/office/drawing/2014/main" id="{7BA1B621-95F1-8312-DC9A-DF8A97F8A4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09923492"/>
              </p:ext>
            </p:extLst>
          </p:nvPr>
        </p:nvGraphicFramePr>
        <p:xfrm>
          <a:off x="769779" y="5860832"/>
          <a:ext cx="6099465" cy="28459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Document" r:id="rId4" imgW="5969000" imgH="2463800" progId="Word.Document.12">
                  <p:embed/>
                </p:oleObj>
              </mc:Choice>
              <mc:Fallback>
                <p:oleObj name="Document" r:id="rId4" imgW="5969000" imgH="2463800" progId="Word.Document.12">
                  <p:embed/>
                  <p:pic>
                    <p:nvPicPr>
                      <p:cNvPr id="12" name="Objet 11">
                        <a:extLst>
                          <a:ext uri="{FF2B5EF4-FFF2-40B4-BE49-F238E27FC236}">
                            <a16:creationId xmlns:a16="http://schemas.microsoft.com/office/drawing/2014/main" id="{63A1FDB5-A55A-2AAD-1E3F-C441D22C02F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69779" y="5860832"/>
                        <a:ext cx="6099465" cy="28459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9692434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 1">
            <a:extLst>
              <a:ext uri="{FF2B5EF4-FFF2-40B4-BE49-F238E27FC236}">
                <a16:creationId xmlns:a16="http://schemas.microsoft.com/office/drawing/2014/main" id="{C87C3E53-C4B8-D3BD-E349-755D262AD6B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86212257"/>
              </p:ext>
            </p:extLst>
          </p:nvPr>
        </p:nvGraphicFramePr>
        <p:xfrm>
          <a:off x="501650" y="848193"/>
          <a:ext cx="5854700" cy="152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Document" r:id="rId2" imgW="5854700" imgH="1524000" progId="Word.Document.12">
                  <p:embed/>
                </p:oleObj>
              </mc:Choice>
              <mc:Fallback>
                <p:oleObj name="Document" r:id="rId2" imgW="5854700" imgH="15240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01650" y="848193"/>
                        <a:ext cx="5854700" cy="152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2">
            <a:extLst>
              <a:ext uri="{FF2B5EF4-FFF2-40B4-BE49-F238E27FC236}">
                <a16:creationId xmlns:a16="http://schemas.microsoft.com/office/drawing/2014/main" id="{68B66DDA-965D-C09D-147B-8013164F9E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1650" y="3282846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graphicFrame>
        <p:nvGraphicFramePr>
          <p:cNvPr id="5" name="Objet 4">
            <a:extLst>
              <a:ext uri="{FF2B5EF4-FFF2-40B4-BE49-F238E27FC236}">
                <a16:creationId xmlns:a16="http://schemas.microsoft.com/office/drawing/2014/main" id="{4699B222-C4A0-989D-C1EB-2D29402AD6D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77828102"/>
              </p:ext>
            </p:extLst>
          </p:nvPr>
        </p:nvGraphicFramePr>
        <p:xfrm>
          <a:off x="501650" y="3282846"/>
          <a:ext cx="5854700" cy="2844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Document" r:id="rId4" imgW="5854700" imgH="2844800" progId="Word.Document.12">
                  <p:embed/>
                </p:oleObj>
              </mc:Choice>
              <mc:Fallback>
                <p:oleObj name="Document" r:id="rId4" imgW="5854700" imgH="2844800" progId="Word.Document.12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01650" y="3282846"/>
                        <a:ext cx="5854700" cy="28448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5126253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 1">
            <a:extLst>
              <a:ext uri="{FF2B5EF4-FFF2-40B4-BE49-F238E27FC236}">
                <a16:creationId xmlns:a16="http://schemas.microsoft.com/office/drawing/2014/main" id="{74461123-8974-F558-689C-D726AD28C2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92344901"/>
              </p:ext>
            </p:extLst>
          </p:nvPr>
        </p:nvGraphicFramePr>
        <p:xfrm>
          <a:off x="488950" y="749300"/>
          <a:ext cx="5880100" cy="840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Document" r:id="rId2" imgW="5880100" imgH="8407400" progId="Word.Document.12">
                  <p:embed/>
                </p:oleObj>
              </mc:Choice>
              <mc:Fallback>
                <p:oleObj name="Document" r:id="rId2" imgW="5880100" imgH="84074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88950" y="749300"/>
                        <a:ext cx="5880100" cy="840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7858125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943</Words>
  <Application>Microsoft Macintosh PowerPoint</Application>
  <PresentationFormat>Format A4 (210 x 297 mm)</PresentationFormat>
  <Paragraphs>80</Paragraphs>
  <Slides>9</Slides>
  <Notes>1</Notes>
  <HiddenSlides>0</HiddenSlides>
  <MMClips>0</MMClips>
  <ScaleCrop>false</ScaleCrop>
  <HeadingPairs>
    <vt:vector size="8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2</vt:i4>
      </vt:variant>
      <vt:variant>
        <vt:lpstr>Titres des diapositives</vt:lpstr>
      </vt:variant>
      <vt:variant>
        <vt:i4>9</vt:i4>
      </vt:variant>
    </vt:vector>
  </HeadingPairs>
  <TitlesOfParts>
    <vt:vector size="17" baseType="lpstr">
      <vt:lpstr>Arial</vt:lpstr>
      <vt:lpstr>Calibri</vt:lpstr>
      <vt:lpstr>Calibri Light</vt:lpstr>
      <vt:lpstr>Cambria Math</vt:lpstr>
      <vt:lpstr>Times New Roman</vt:lpstr>
      <vt:lpstr>Thème Office</vt:lpstr>
      <vt:lpstr>Prism 9</vt:lpstr>
      <vt:lpstr>Docume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ie-Gabrielle Zurich Fontanellaz</dc:creator>
  <cp:lastModifiedBy>Marie-Gabrielle Zurich</cp:lastModifiedBy>
  <cp:revision>64</cp:revision>
  <cp:lastPrinted>2022-03-24T10:52:47Z</cp:lastPrinted>
  <dcterms:created xsi:type="dcterms:W3CDTF">2021-09-03T08:41:31Z</dcterms:created>
  <dcterms:modified xsi:type="dcterms:W3CDTF">2023-07-21T18:00:42Z</dcterms:modified>
</cp:coreProperties>
</file>